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414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602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715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629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804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89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584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2686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8331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414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724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917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Rectangle 5"/>
          <p:cNvSpPr>
            <a:spLocks noChangeArrowheads="1"/>
          </p:cNvSpPr>
          <p:nvPr/>
        </p:nvSpPr>
        <p:spPr bwMode="auto">
          <a:xfrm>
            <a:off x="6491706" y="1541728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3" name="テキスト ボックス 222"/>
          <p:cNvSpPr txBox="1"/>
          <p:nvPr/>
        </p:nvSpPr>
        <p:spPr>
          <a:xfrm rot="16200000">
            <a:off x="-576404" y="3453764"/>
            <a:ext cx="2039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ability of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304828" y="125202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1" name="直線コネクタ 230"/>
          <p:cNvCxnSpPr>
            <a:cxnSpLocks/>
          </p:cNvCxnSpPr>
          <p:nvPr/>
        </p:nvCxnSpPr>
        <p:spPr>
          <a:xfrm>
            <a:off x="112543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Rectangle 45"/>
          <p:cNvSpPr>
            <a:spLocks noChangeArrowheads="1"/>
          </p:cNvSpPr>
          <p:nvPr/>
        </p:nvSpPr>
        <p:spPr bwMode="auto">
          <a:xfrm>
            <a:off x="2660873" y="5685635"/>
            <a:ext cx="7662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(months)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0D16A516-FEB2-4F73-91FB-2AB85585D3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415" y="1714573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6">
            <a:extLst>
              <a:ext uri="{FF2B5EF4-FFF2-40B4-BE49-F238E27FC236}">
                <a16:creationId xmlns:a16="http://schemas.microsoft.com/office/drawing/2014/main" id="{BE84D229-619B-468D-95C5-B45E9854785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5171189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7">
            <a:extLst>
              <a:ext uri="{FF2B5EF4-FFF2-40B4-BE49-F238E27FC236}">
                <a16:creationId xmlns:a16="http://schemas.microsoft.com/office/drawing/2014/main" id="{10D4E839-9E80-432E-A182-0A699C6251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501562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8">
            <a:extLst>
              <a:ext uri="{FF2B5EF4-FFF2-40B4-BE49-F238E27FC236}">
                <a16:creationId xmlns:a16="http://schemas.microsoft.com/office/drawing/2014/main" id="{242E5E79-09D4-4A46-B46B-E922A3C4BCB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4894637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9">
            <a:extLst>
              <a:ext uri="{FF2B5EF4-FFF2-40B4-BE49-F238E27FC236}">
                <a16:creationId xmlns:a16="http://schemas.microsoft.com/office/drawing/2014/main" id="{BC924F31-0A5C-4F76-B00F-8FB09DBAD0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4600800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10">
            <a:extLst>
              <a:ext uri="{FF2B5EF4-FFF2-40B4-BE49-F238E27FC236}">
                <a16:creationId xmlns:a16="http://schemas.microsoft.com/office/drawing/2014/main" id="{D9F7E4A1-EA30-4CEA-9BC8-B583BDF4FD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444524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1">
            <a:extLst>
              <a:ext uri="{FF2B5EF4-FFF2-40B4-BE49-F238E27FC236}">
                <a16:creationId xmlns:a16="http://schemas.microsoft.com/office/drawing/2014/main" id="{C3E5F41F-0ECF-4ADD-B909-6F0B4D671D7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4324248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2">
            <a:extLst>
              <a:ext uri="{FF2B5EF4-FFF2-40B4-BE49-F238E27FC236}">
                <a16:creationId xmlns:a16="http://schemas.microsoft.com/office/drawing/2014/main" id="{83E771B0-952A-455E-84E1-4DED48BC916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4047696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3">
            <a:extLst>
              <a:ext uri="{FF2B5EF4-FFF2-40B4-BE49-F238E27FC236}">
                <a16:creationId xmlns:a16="http://schemas.microsoft.com/office/drawing/2014/main" id="{2B859742-3822-40C3-A799-3F8F4F74BB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389213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4">
            <a:extLst>
              <a:ext uri="{FF2B5EF4-FFF2-40B4-BE49-F238E27FC236}">
                <a16:creationId xmlns:a16="http://schemas.microsoft.com/office/drawing/2014/main" id="{1CC2462B-DD3D-400A-9C5F-E9D8BD66A67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3771145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15">
            <a:extLst>
              <a:ext uri="{FF2B5EF4-FFF2-40B4-BE49-F238E27FC236}">
                <a16:creationId xmlns:a16="http://schemas.microsoft.com/office/drawing/2014/main" id="{AE08AEE6-AEAB-47DE-B6CC-6152AD14618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3477308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6">
            <a:extLst>
              <a:ext uri="{FF2B5EF4-FFF2-40B4-BE49-F238E27FC236}">
                <a16:creationId xmlns:a16="http://schemas.microsoft.com/office/drawing/2014/main" id="{1B8B6E12-1D84-40DF-A3EF-49B449391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332174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17">
            <a:extLst>
              <a:ext uri="{FF2B5EF4-FFF2-40B4-BE49-F238E27FC236}">
                <a16:creationId xmlns:a16="http://schemas.microsoft.com/office/drawing/2014/main" id="{DCA29EEE-F57A-4CC0-A340-35300729163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3200756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Line 18">
            <a:extLst>
              <a:ext uri="{FF2B5EF4-FFF2-40B4-BE49-F238E27FC236}">
                <a16:creationId xmlns:a16="http://schemas.microsoft.com/office/drawing/2014/main" id="{CF7502B1-BD21-4A85-AA6D-2120633E3C1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2924204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FF30BA54-1CA1-4B1E-97AA-1227F91993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2768644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20">
            <a:extLst>
              <a:ext uri="{FF2B5EF4-FFF2-40B4-BE49-F238E27FC236}">
                <a16:creationId xmlns:a16="http://schemas.microsoft.com/office/drawing/2014/main" id="{3BC91216-A3EA-4BFC-9533-AD00CD22068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2630368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1">
            <a:extLst>
              <a:ext uri="{FF2B5EF4-FFF2-40B4-BE49-F238E27FC236}">
                <a16:creationId xmlns:a16="http://schemas.microsoft.com/office/drawing/2014/main" id="{1AF1DDAA-9AFE-4DAF-B717-5810F932B21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2353816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2">
            <a:extLst>
              <a:ext uri="{FF2B5EF4-FFF2-40B4-BE49-F238E27FC236}">
                <a16:creationId xmlns:a16="http://schemas.microsoft.com/office/drawing/2014/main" id="{06297F4B-C01D-4921-8AAB-90C3DBF0E0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219825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3">
            <a:extLst>
              <a:ext uri="{FF2B5EF4-FFF2-40B4-BE49-F238E27FC236}">
                <a16:creationId xmlns:a16="http://schemas.microsoft.com/office/drawing/2014/main" id="{BA8BD32B-ED0E-4474-8CF9-2F2C9D1B130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2077264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31">
            <a:extLst>
              <a:ext uri="{FF2B5EF4-FFF2-40B4-BE49-F238E27FC236}">
                <a16:creationId xmlns:a16="http://schemas.microsoft.com/office/drawing/2014/main" id="{0D0BC4AE-28E6-4962-A895-AB7345024366}"/>
              </a:ext>
            </a:extLst>
          </p:cNvPr>
          <p:cNvSpPr>
            <a:spLocks noChangeShapeType="1"/>
          </p:cNvSpPr>
          <p:nvPr/>
        </p:nvSpPr>
        <p:spPr bwMode="auto">
          <a:xfrm>
            <a:off x="1143226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2">
            <a:extLst>
              <a:ext uri="{FF2B5EF4-FFF2-40B4-BE49-F238E27FC236}">
                <a16:creationId xmlns:a16="http://schemas.microsoft.com/office/drawing/2014/main" id="{5811A09A-784B-440F-9337-53585F2051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2776" y="529218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ine 33">
            <a:extLst>
              <a:ext uri="{FF2B5EF4-FFF2-40B4-BE49-F238E27FC236}">
                <a16:creationId xmlns:a16="http://schemas.microsoft.com/office/drawing/2014/main" id="{07ADA2E6-1D43-496E-A7B1-BE8E546D708A}"/>
              </a:ext>
            </a:extLst>
          </p:cNvPr>
          <p:cNvSpPr>
            <a:spLocks noChangeShapeType="1"/>
          </p:cNvSpPr>
          <p:nvPr/>
        </p:nvSpPr>
        <p:spPr bwMode="auto">
          <a:xfrm>
            <a:off x="1611712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4">
            <a:extLst>
              <a:ext uri="{FF2B5EF4-FFF2-40B4-BE49-F238E27FC236}">
                <a16:creationId xmlns:a16="http://schemas.microsoft.com/office/drawing/2014/main" id="{155E41A4-2AA0-4A8E-9C61-B836DCDDF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5925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Line 35">
            <a:extLst>
              <a:ext uri="{FF2B5EF4-FFF2-40B4-BE49-F238E27FC236}">
                <a16:creationId xmlns:a16="http://schemas.microsoft.com/office/drawing/2014/main" id="{7B1D6A61-3620-4F9E-A530-7DCE8F5F2690}"/>
              </a:ext>
            </a:extLst>
          </p:cNvPr>
          <p:cNvSpPr>
            <a:spLocks noChangeShapeType="1"/>
          </p:cNvSpPr>
          <p:nvPr/>
        </p:nvSpPr>
        <p:spPr bwMode="auto">
          <a:xfrm>
            <a:off x="2065086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6">
            <a:extLst>
              <a:ext uri="{FF2B5EF4-FFF2-40B4-BE49-F238E27FC236}">
                <a16:creationId xmlns:a16="http://schemas.microsoft.com/office/drawing/2014/main" id="{B14755DD-3E36-4DDB-960C-D873AAD35D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9298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37">
            <a:extLst>
              <a:ext uri="{FF2B5EF4-FFF2-40B4-BE49-F238E27FC236}">
                <a16:creationId xmlns:a16="http://schemas.microsoft.com/office/drawing/2014/main" id="{77559B91-187B-4C8E-96F2-287C71B2460A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3572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8">
            <a:extLst>
              <a:ext uri="{FF2B5EF4-FFF2-40B4-BE49-F238E27FC236}">
                <a16:creationId xmlns:a16="http://schemas.microsoft.com/office/drawing/2014/main" id="{50ED7680-F99A-4030-BE49-B3FDA1C2CC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7785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39">
            <a:extLst>
              <a:ext uri="{FF2B5EF4-FFF2-40B4-BE49-F238E27FC236}">
                <a16:creationId xmlns:a16="http://schemas.microsoft.com/office/drawing/2014/main" id="{8D35985E-B668-4075-843F-D3DB2F5D9507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2058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0">
            <a:extLst>
              <a:ext uri="{FF2B5EF4-FFF2-40B4-BE49-F238E27FC236}">
                <a16:creationId xmlns:a16="http://schemas.microsoft.com/office/drawing/2014/main" id="{35452AD7-519C-43E3-9398-642DF1CF03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6271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Line 41">
            <a:extLst>
              <a:ext uri="{FF2B5EF4-FFF2-40B4-BE49-F238E27FC236}">
                <a16:creationId xmlns:a16="http://schemas.microsoft.com/office/drawing/2014/main" id="{48F948EE-346D-4898-BAE0-60C351BE9822}"/>
              </a:ext>
            </a:extLst>
          </p:cNvPr>
          <p:cNvSpPr>
            <a:spLocks noChangeShapeType="1"/>
          </p:cNvSpPr>
          <p:nvPr/>
        </p:nvSpPr>
        <p:spPr bwMode="auto">
          <a:xfrm>
            <a:off x="3455431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2">
            <a:extLst>
              <a:ext uri="{FF2B5EF4-FFF2-40B4-BE49-F238E27FC236}">
                <a16:creationId xmlns:a16="http://schemas.microsoft.com/office/drawing/2014/main" id="{B930FA52-6C98-4F8B-8900-873CF4BB6D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9194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Line 43">
            <a:extLst>
              <a:ext uri="{FF2B5EF4-FFF2-40B4-BE49-F238E27FC236}">
                <a16:creationId xmlns:a16="http://schemas.microsoft.com/office/drawing/2014/main" id="{B59E7796-2671-4A0B-A491-5DA56700F405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3918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4">
            <a:extLst>
              <a:ext uri="{FF2B5EF4-FFF2-40B4-BE49-F238E27FC236}">
                <a16:creationId xmlns:a16="http://schemas.microsoft.com/office/drawing/2014/main" id="{73CB49E7-B867-4215-A23B-05264D3E07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7681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45">
            <a:extLst>
              <a:ext uri="{FF2B5EF4-FFF2-40B4-BE49-F238E27FC236}">
                <a16:creationId xmlns:a16="http://schemas.microsoft.com/office/drawing/2014/main" id="{63588320-B97E-4A4F-80A0-77E42AA8D804}"/>
              </a:ext>
            </a:extLst>
          </p:cNvPr>
          <p:cNvSpPr>
            <a:spLocks noChangeShapeType="1"/>
          </p:cNvSpPr>
          <p:nvPr/>
        </p:nvSpPr>
        <p:spPr bwMode="auto">
          <a:xfrm>
            <a:off x="4392404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6">
            <a:extLst>
              <a:ext uri="{FF2B5EF4-FFF2-40B4-BE49-F238E27FC236}">
                <a16:creationId xmlns:a16="http://schemas.microsoft.com/office/drawing/2014/main" id="{97FEADFE-8F12-446A-8279-03BCBD14DD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6167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4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47">
            <a:extLst>
              <a:ext uri="{FF2B5EF4-FFF2-40B4-BE49-F238E27FC236}">
                <a16:creationId xmlns:a16="http://schemas.microsoft.com/office/drawing/2014/main" id="{15684B31-E813-47FA-98D7-1AB35451FFC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45777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8">
            <a:extLst>
              <a:ext uri="{FF2B5EF4-FFF2-40B4-BE49-F238E27FC236}">
                <a16:creationId xmlns:a16="http://schemas.microsoft.com/office/drawing/2014/main" id="{68AC94EE-86C9-4745-B2BB-4FDE5C9816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9540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6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Line 49">
            <a:extLst>
              <a:ext uri="{FF2B5EF4-FFF2-40B4-BE49-F238E27FC236}">
                <a16:creationId xmlns:a16="http://schemas.microsoft.com/office/drawing/2014/main" id="{772C745F-3507-4F27-9AFC-B8A3F0122E1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14263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0">
            <a:extLst>
              <a:ext uri="{FF2B5EF4-FFF2-40B4-BE49-F238E27FC236}">
                <a16:creationId xmlns:a16="http://schemas.microsoft.com/office/drawing/2014/main" id="{1D731564-DB31-475C-AFB5-664DD58289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8026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8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A25430E8-3546-4793-8522-643EB81867A5}"/>
              </a:ext>
            </a:extLst>
          </p:cNvPr>
          <p:cNvCxnSpPr/>
          <p:nvPr/>
        </p:nvCxnSpPr>
        <p:spPr>
          <a:xfrm flipV="1">
            <a:off x="1140228" y="2043837"/>
            <a:ext cx="0" cy="3111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2460ABA4-86B4-4656-9EA3-CB2EE662414D}"/>
              </a:ext>
            </a:extLst>
          </p:cNvPr>
          <p:cNvCxnSpPr/>
          <p:nvPr/>
        </p:nvCxnSpPr>
        <p:spPr>
          <a:xfrm>
            <a:off x="1120557" y="5171189"/>
            <a:ext cx="4171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テキスト ボックス 280"/>
          <p:cNvSpPr txBox="1"/>
          <p:nvPr/>
        </p:nvSpPr>
        <p:spPr>
          <a:xfrm rot="16200000">
            <a:off x="5323044" y="3286833"/>
            <a:ext cx="2373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disease-free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Rectangle 54"/>
          <p:cNvSpPr>
            <a:spLocks noChangeArrowheads="1"/>
          </p:cNvSpPr>
          <p:nvPr/>
        </p:nvSpPr>
        <p:spPr bwMode="auto">
          <a:xfrm>
            <a:off x="6652855" y="185285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62">
            <a:extLst>
              <a:ext uri="{FF2B5EF4-FFF2-40B4-BE49-F238E27FC236}">
                <a16:creationId xmlns:a16="http://schemas.microsoft.com/office/drawing/2014/main" id="{9FBBA5ED-C602-4186-ADC1-651233C5E6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001" y="158494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8" name="テキスト ボックス 277"/>
          <p:cNvSpPr txBox="1"/>
          <p:nvPr/>
        </p:nvSpPr>
        <p:spPr>
          <a:xfrm>
            <a:off x="6344898" y="12520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663306B6-7D8A-459E-89F8-B2944FB88A1C}"/>
              </a:ext>
            </a:extLst>
          </p:cNvPr>
          <p:cNvGrpSpPr/>
          <p:nvPr/>
        </p:nvGrpSpPr>
        <p:grpSpPr>
          <a:xfrm>
            <a:off x="6886634" y="2077271"/>
            <a:ext cx="4590085" cy="3762263"/>
            <a:chOff x="7459931" y="1690480"/>
            <a:chExt cx="3857353" cy="2764367"/>
          </a:xfrm>
        </p:grpSpPr>
        <p:sp>
          <p:nvSpPr>
            <p:cNvPr id="65" name="Line 63">
              <a:extLst>
                <a:ext uri="{FF2B5EF4-FFF2-40B4-BE49-F238E27FC236}">
                  <a16:creationId xmlns:a16="http://schemas.microsoft.com/office/drawing/2014/main" id="{622DD66F-18D2-4ECE-BE62-E2343F9A14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9764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4">
              <a:extLst>
                <a:ext uri="{FF2B5EF4-FFF2-40B4-BE49-F238E27FC236}">
                  <a16:creationId xmlns:a16="http://schemas.microsoft.com/office/drawing/2014/main" id="{A2DBD214-998E-4EE5-A8FA-8C87EC670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8621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65">
              <a:extLst>
                <a:ext uri="{FF2B5EF4-FFF2-40B4-BE49-F238E27FC236}">
                  <a16:creationId xmlns:a16="http://schemas.microsoft.com/office/drawing/2014/main" id="{AF9429A1-02A3-4310-A54A-AE3782B254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7732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66">
              <a:extLst>
                <a:ext uri="{FF2B5EF4-FFF2-40B4-BE49-F238E27FC236}">
                  <a16:creationId xmlns:a16="http://schemas.microsoft.com/office/drawing/2014/main" id="{957DED8C-388F-47AF-88B5-A432969369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5573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7">
              <a:extLst>
                <a:ext uri="{FF2B5EF4-FFF2-40B4-BE49-F238E27FC236}">
                  <a16:creationId xmlns:a16="http://schemas.microsoft.com/office/drawing/2014/main" id="{E803655E-3DA6-4F0E-AE6D-62A0ADBDB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4430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68">
              <a:extLst>
                <a:ext uri="{FF2B5EF4-FFF2-40B4-BE49-F238E27FC236}">
                  <a16:creationId xmlns:a16="http://schemas.microsoft.com/office/drawing/2014/main" id="{32F18796-0943-4A0B-AFD0-2471AE67D7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3541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69">
              <a:extLst>
                <a:ext uri="{FF2B5EF4-FFF2-40B4-BE49-F238E27FC236}">
                  <a16:creationId xmlns:a16="http://schemas.microsoft.com/office/drawing/2014/main" id="{4C2D2B19-EFDD-4C38-9822-D176CB42B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1509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0">
              <a:extLst>
                <a:ext uri="{FF2B5EF4-FFF2-40B4-BE49-F238E27FC236}">
                  <a16:creationId xmlns:a16="http://schemas.microsoft.com/office/drawing/2014/main" id="{75CC0B42-73D7-4A50-A3E3-E3FE4AFE94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0366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71">
              <a:extLst>
                <a:ext uri="{FF2B5EF4-FFF2-40B4-BE49-F238E27FC236}">
                  <a16:creationId xmlns:a16="http://schemas.microsoft.com/office/drawing/2014/main" id="{7C36C47F-50AA-45A3-9029-7A407D0F76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72">
              <a:extLst>
                <a:ext uri="{FF2B5EF4-FFF2-40B4-BE49-F238E27FC236}">
                  <a16:creationId xmlns:a16="http://schemas.microsoft.com/office/drawing/2014/main" id="{7197086E-67D4-4153-87B8-6219A5332D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7318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3">
              <a:extLst>
                <a:ext uri="{FF2B5EF4-FFF2-40B4-BE49-F238E27FC236}">
                  <a16:creationId xmlns:a16="http://schemas.microsoft.com/office/drawing/2014/main" id="{2F6CF6FE-E265-4124-9602-0618CF5594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6175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4">
              <a:extLst>
                <a:ext uri="{FF2B5EF4-FFF2-40B4-BE49-F238E27FC236}">
                  <a16:creationId xmlns:a16="http://schemas.microsoft.com/office/drawing/2014/main" id="{7B3EB37F-9590-4E96-B8C7-9D2EDD18F2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75">
              <a:extLst>
                <a:ext uri="{FF2B5EF4-FFF2-40B4-BE49-F238E27FC236}">
                  <a16:creationId xmlns:a16="http://schemas.microsoft.com/office/drawing/2014/main" id="{FF2B42B7-8D93-4628-BCC7-F782E92B4D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6">
              <a:extLst>
                <a:ext uri="{FF2B5EF4-FFF2-40B4-BE49-F238E27FC236}">
                  <a16:creationId xmlns:a16="http://schemas.microsoft.com/office/drawing/2014/main" id="{8A1800C4-5C93-43F5-A974-0CDD854466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77">
              <a:extLst>
                <a:ext uri="{FF2B5EF4-FFF2-40B4-BE49-F238E27FC236}">
                  <a16:creationId xmlns:a16="http://schemas.microsoft.com/office/drawing/2014/main" id="{DD131605-0106-4546-8556-F4AE3A8916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109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Line 78">
              <a:extLst>
                <a:ext uri="{FF2B5EF4-FFF2-40B4-BE49-F238E27FC236}">
                  <a16:creationId xmlns:a16="http://schemas.microsoft.com/office/drawing/2014/main" id="{0DDDF813-2AF2-4147-A3BD-BA189753CD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79">
              <a:extLst>
                <a:ext uri="{FF2B5EF4-FFF2-40B4-BE49-F238E27FC236}">
                  <a16:creationId xmlns:a16="http://schemas.microsoft.com/office/drawing/2014/main" id="{9BA0F6EE-9C5D-4F02-A225-0A01951E6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80">
              <a:extLst>
                <a:ext uri="{FF2B5EF4-FFF2-40B4-BE49-F238E27FC236}">
                  <a16:creationId xmlns:a16="http://schemas.microsoft.com/office/drawing/2014/main" id="{12F1849C-DFD8-4866-82A9-B88E94ED97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88">
              <a:extLst>
                <a:ext uri="{FF2B5EF4-FFF2-40B4-BE49-F238E27FC236}">
                  <a16:creationId xmlns:a16="http://schemas.microsoft.com/office/drawing/2014/main" id="{B28D5815-4980-434A-A233-95B81578C9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01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89">
              <a:extLst>
                <a:ext uri="{FF2B5EF4-FFF2-40B4-BE49-F238E27FC236}">
                  <a16:creationId xmlns:a16="http://schemas.microsoft.com/office/drawing/2014/main" id="{8E839CC2-6A63-468F-A233-53199B80B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9331" y="40653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90">
              <a:extLst>
                <a:ext uri="{FF2B5EF4-FFF2-40B4-BE49-F238E27FC236}">
                  <a16:creationId xmlns:a16="http://schemas.microsoft.com/office/drawing/2014/main" id="{277E2621-0C8B-46A1-91F3-902ADE5A22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3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1">
              <a:extLst>
                <a:ext uri="{FF2B5EF4-FFF2-40B4-BE49-F238E27FC236}">
                  <a16:creationId xmlns:a16="http://schemas.microsoft.com/office/drawing/2014/main" id="{6D86256B-F9A2-45CB-B78A-4CE30CB8C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4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92">
              <a:extLst>
                <a:ext uri="{FF2B5EF4-FFF2-40B4-BE49-F238E27FC236}">
                  <a16:creationId xmlns:a16="http://schemas.microsoft.com/office/drawing/2014/main" id="{C4DC2F4C-6D4F-474E-9926-9C84FC5B24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4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3">
              <a:extLst>
                <a:ext uri="{FF2B5EF4-FFF2-40B4-BE49-F238E27FC236}">
                  <a16:creationId xmlns:a16="http://schemas.microsoft.com/office/drawing/2014/main" id="{05111821-4A6A-4DE9-BA65-49B6F10F5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75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Line 94">
              <a:extLst>
                <a:ext uri="{FF2B5EF4-FFF2-40B4-BE49-F238E27FC236}">
                  <a16:creationId xmlns:a16="http://schemas.microsoft.com/office/drawing/2014/main" id="{8D25425C-FA5E-451F-AA11-E8D63550F4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585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5">
              <a:extLst>
                <a:ext uri="{FF2B5EF4-FFF2-40B4-BE49-F238E27FC236}">
                  <a16:creationId xmlns:a16="http://schemas.microsoft.com/office/drawing/2014/main" id="{EF8B8AA4-937F-4477-AB49-E8438A7175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96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F9DFFE10-36C4-49DE-8820-37ED4CBB17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52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EA951F92-DDC0-4063-871A-CD28031C9C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33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Line 98">
              <a:extLst>
                <a:ext uri="{FF2B5EF4-FFF2-40B4-BE49-F238E27FC236}">
                  <a16:creationId xmlns:a16="http://schemas.microsoft.com/office/drawing/2014/main" id="{8496229B-E404-4B32-9751-F050A19AE5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33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99">
              <a:extLst>
                <a:ext uri="{FF2B5EF4-FFF2-40B4-BE49-F238E27FC236}">
                  <a16:creationId xmlns:a16="http://schemas.microsoft.com/office/drawing/2014/main" id="{2E049407-B8A2-43C8-AE7C-13E96511BF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935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Line 100">
              <a:extLst>
                <a:ext uri="{FF2B5EF4-FFF2-40B4-BE49-F238E27FC236}">
                  <a16:creationId xmlns:a16="http://schemas.microsoft.com/office/drawing/2014/main" id="{6D9C17AD-43D8-43D8-977E-5AC4ACFBF3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69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01">
              <a:extLst>
                <a:ext uri="{FF2B5EF4-FFF2-40B4-BE49-F238E27FC236}">
                  <a16:creationId xmlns:a16="http://schemas.microsoft.com/office/drawing/2014/main" id="{D4216814-42CB-433A-88EE-013BA41EC8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72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Line 102">
              <a:extLst>
                <a:ext uri="{FF2B5EF4-FFF2-40B4-BE49-F238E27FC236}">
                  <a16:creationId xmlns:a16="http://schemas.microsoft.com/office/drawing/2014/main" id="{5CBF347C-EB80-43D0-A5A0-9BF4B5E332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0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03">
              <a:extLst>
                <a:ext uri="{FF2B5EF4-FFF2-40B4-BE49-F238E27FC236}">
                  <a16:creationId xmlns:a16="http://schemas.microsoft.com/office/drawing/2014/main" id="{9FE0AABE-F48D-49D9-A6E3-868CEA165C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Line 104">
              <a:extLst>
                <a:ext uri="{FF2B5EF4-FFF2-40B4-BE49-F238E27FC236}">
                  <a16:creationId xmlns:a16="http://schemas.microsoft.com/office/drawing/2014/main" id="{2E3508CC-B739-412E-8ED7-C016FF8DAD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01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105">
              <a:extLst>
                <a:ext uri="{FF2B5EF4-FFF2-40B4-BE49-F238E27FC236}">
                  <a16:creationId xmlns:a16="http://schemas.microsoft.com/office/drawing/2014/main" id="{D052E872-A040-49E1-B056-F6CD9E25B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1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Line 106">
              <a:extLst>
                <a:ext uri="{FF2B5EF4-FFF2-40B4-BE49-F238E27FC236}">
                  <a16:creationId xmlns:a16="http://schemas.microsoft.com/office/drawing/2014/main" id="{9C548FF1-3544-417F-87BA-65283046A2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953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07">
              <a:extLst>
                <a:ext uri="{FF2B5EF4-FFF2-40B4-BE49-F238E27FC236}">
                  <a16:creationId xmlns:a16="http://schemas.microsoft.com/office/drawing/2014/main" id="{3BD3F640-0B90-40FF-AAA8-31E8AC9E9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556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492DDF6B-2906-4DDB-91D2-FF91A6E46CD4}"/>
                </a:ext>
              </a:extLst>
            </p:cNvPr>
            <p:cNvGrpSpPr/>
            <p:nvPr/>
          </p:nvGrpSpPr>
          <p:grpSpPr>
            <a:xfrm>
              <a:off x="7790131" y="1690480"/>
              <a:ext cx="3505200" cy="2764367"/>
              <a:chOff x="7009954" y="1690480"/>
              <a:chExt cx="3505200" cy="2764367"/>
            </a:xfrm>
          </p:grpSpPr>
          <p:sp>
            <p:nvSpPr>
              <p:cNvPr id="283" name="Rectangle 45"/>
              <p:cNvSpPr>
                <a:spLocks noChangeArrowheads="1"/>
              </p:cNvSpPr>
              <p:nvPr/>
            </p:nvSpPr>
            <p:spPr bwMode="auto">
              <a:xfrm>
                <a:off x="8304384" y="4341776"/>
                <a:ext cx="643918" cy="113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Time (months)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A3C0B6BF-E8EE-462C-B15A-49E7FA3ACAB0}"/>
                  </a:ext>
                </a:extLst>
              </p:cNvPr>
              <p:cNvGrpSpPr/>
              <p:nvPr/>
            </p:nvGrpSpPr>
            <p:grpSpPr>
              <a:xfrm>
                <a:off x="7009954" y="1690480"/>
                <a:ext cx="3505200" cy="2286000"/>
                <a:chOff x="7009954" y="1690480"/>
                <a:chExt cx="3505200" cy="2286000"/>
              </a:xfrm>
            </p:grpSpPr>
            <p:cxnSp>
              <p:nvCxnSpPr>
                <p:cNvPr id="220" name="直線コネクタ 219">
                  <a:extLst>
                    <a:ext uri="{FF2B5EF4-FFF2-40B4-BE49-F238E27FC236}">
                      <a16:creationId xmlns:a16="http://schemas.microsoft.com/office/drawing/2014/main" id="{7868AD88-EA69-4B42-914C-2556DE68218F}"/>
                    </a:ext>
                  </a:extLst>
                </p:cNvPr>
                <p:cNvCxnSpPr/>
                <p:nvPr/>
              </p:nvCxnSpPr>
              <p:spPr>
                <a:xfrm flipV="1">
                  <a:off x="7009954" y="1690480"/>
                  <a:ext cx="0" cy="228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67FAB179-DF8D-4449-83D3-ABB2A8BF2897}"/>
                    </a:ext>
                  </a:extLst>
                </p:cNvPr>
                <p:cNvCxnSpPr/>
                <p:nvPr/>
              </p:nvCxnSpPr>
              <p:spPr>
                <a:xfrm>
                  <a:off x="7009954" y="3972169"/>
                  <a:ext cx="3505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09430355-0F4B-4AC1-A87D-306C0D6F8B5D}"/>
              </a:ext>
            </a:extLst>
          </p:cNvPr>
          <p:cNvCxnSpPr>
            <a:cxnSpLocks/>
          </p:cNvCxnSpPr>
          <p:nvPr/>
        </p:nvCxnSpPr>
        <p:spPr>
          <a:xfrm>
            <a:off x="746419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80CFFC3F-491B-4F9E-B364-6DBC3020C535}"/>
              </a:ext>
            </a:extLst>
          </p:cNvPr>
          <p:cNvSpPr txBox="1"/>
          <p:nvPr/>
        </p:nvSpPr>
        <p:spPr>
          <a:xfrm>
            <a:off x="4216411" y="270029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umin high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50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497C2860-82EC-4F7F-A182-5D345BBD42BE}"/>
              </a:ext>
            </a:extLst>
          </p:cNvPr>
          <p:cNvSpPr txBox="1"/>
          <p:nvPr/>
        </p:nvSpPr>
        <p:spPr>
          <a:xfrm>
            <a:off x="4216411" y="4204283"/>
            <a:ext cx="8611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umin low 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43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DCDCB375-2478-460E-A0F9-82B42B4EFF6E}"/>
              </a:ext>
            </a:extLst>
          </p:cNvPr>
          <p:cNvSpPr txBox="1"/>
          <p:nvPr/>
        </p:nvSpPr>
        <p:spPr>
          <a:xfrm>
            <a:off x="1276660" y="4797972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00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9</a:t>
            </a:r>
            <a:endParaRPr kumimoji="1" lang="ja-JP" altLang="en-US" sz="10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8B3D097E-CABF-4A85-81CF-86CFD8EAB957}"/>
              </a:ext>
            </a:extLst>
          </p:cNvPr>
          <p:cNvSpPr txBox="1"/>
          <p:nvPr/>
        </p:nvSpPr>
        <p:spPr>
          <a:xfrm>
            <a:off x="7396376" y="4843035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00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5</a:t>
            </a:r>
            <a:endParaRPr kumimoji="1" lang="ja-JP" altLang="en-US" sz="10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Freeform 28">
            <a:extLst>
              <a:ext uri="{FF2B5EF4-FFF2-40B4-BE49-F238E27FC236}">
                <a16:creationId xmlns:a16="http://schemas.microsoft.com/office/drawing/2014/main" id="{0C923483-6CAF-4DA9-AF2C-57FA7FFFB776}"/>
              </a:ext>
            </a:extLst>
          </p:cNvPr>
          <p:cNvSpPr>
            <a:spLocks/>
          </p:cNvSpPr>
          <p:nvPr/>
        </p:nvSpPr>
        <p:spPr bwMode="auto">
          <a:xfrm>
            <a:off x="1107920" y="2363543"/>
            <a:ext cx="3214688" cy="746125"/>
          </a:xfrm>
          <a:custGeom>
            <a:avLst/>
            <a:gdLst>
              <a:gd name="T0" fmla="*/ 0 w 4049"/>
              <a:gd name="T1" fmla="*/ 0 h 939"/>
              <a:gd name="T2" fmla="*/ 386 w 4049"/>
              <a:gd name="T3" fmla="*/ 0 h 939"/>
              <a:gd name="T4" fmla="*/ 426 w 4049"/>
              <a:gd name="T5" fmla="*/ 0 h 939"/>
              <a:gd name="T6" fmla="*/ 426 w 4049"/>
              <a:gd name="T7" fmla="*/ 67 h 939"/>
              <a:gd name="T8" fmla="*/ 451 w 4049"/>
              <a:gd name="T9" fmla="*/ 67 h 939"/>
              <a:gd name="T10" fmla="*/ 451 w 4049"/>
              <a:gd name="T11" fmla="*/ 136 h 939"/>
              <a:gd name="T12" fmla="*/ 643 w 4049"/>
              <a:gd name="T13" fmla="*/ 136 h 939"/>
              <a:gd name="T14" fmla="*/ 716 w 4049"/>
              <a:gd name="T15" fmla="*/ 136 h 939"/>
              <a:gd name="T16" fmla="*/ 762 w 4049"/>
              <a:gd name="T17" fmla="*/ 136 h 939"/>
              <a:gd name="T18" fmla="*/ 762 w 4049"/>
              <a:gd name="T19" fmla="*/ 209 h 939"/>
              <a:gd name="T20" fmla="*/ 781 w 4049"/>
              <a:gd name="T21" fmla="*/ 209 h 939"/>
              <a:gd name="T22" fmla="*/ 787 w 4049"/>
              <a:gd name="T23" fmla="*/ 209 h 939"/>
              <a:gd name="T24" fmla="*/ 837 w 4049"/>
              <a:gd name="T25" fmla="*/ 209 h 939"/>
              <a:gd name="T26" fmla="*/ 837 w 4049"/>
              <a:gd name="T27" fmla="*/ 288 h 939"/>
              <a:gd name="T28" fmla="*/ 877 w 4049"/>
              <a:gd name="T29" fmla="*/ 288 h 939"/>
              <a:gd name="T30" fmla="*/ 877 w 4049"/>
              <a:gd name="T31" fmla="*/ 369 h 939"/>
              <a:gd name="T32" fmla="*/ 956 w 4049"/>
              <a:gd name="T33" fmla="*/ 369 h 939"/>
              <a:gd name="T34" fmla="*/ 956 w 4049"/>
              <a:gd name="T35" fmla="*/ 450 h 939"/>
              <a:gd name="T36" fmla="*/ 960 w 4049"/>
              <a:gd name="T37" fmla="*/ 530 h 939"/>
              <a:gd name="T38" fmla="*/ 992 w 4049"/>
              <a:gd name="T39" fmla="*/ 530 h 939"/>
              <a:gd name="T40" fmla="*/ 1056 w 4049"/>
              <a:gd name="T41" fmla="*/ 530 h 939"/>
              <a:gd name="T42" fmla="*/ 1157 w 4049"/>
              <a:gd name="T43" fmla="*/ 530 h 939"/>
              <a:gd name="T44" fmla="*/ 1206 w 4049"/>
              <a:gd name="T45" fmla="*/ 530 h 939"/>
              <a:gd name="T46" fmla="*/ 1206 w 4049"/>
              <a:gd name="T47" fmla="*/ 619 h 939"/>
              <a:gd name="T48" fmla="*/ 1244 w 4049"/>
              <a:gd name="T49" fmla="*/ 619 h 939"/>
              <a:gd name="T50" fmla="*/ 1244 w 4049"/>
              <a:gd name="T51" fmla="*/ 707 h 939"/>
              <a:gd name="T52" fmla="*/ 1336 w 4049"/>
              <a:gd name="T53" fmla="*/ 707 h 939"/>
              <a:gd name="T54" fmla="*/ 1415 w 4049"/>
              <a:gd name="T55" fmla="*/ 707 h 939"/>
              <a:gd name="T56" fmla="*/ 1461 w 4049"/>
              <a:gd name="T57" fmla="*/ 707 h 939"/>
              <a:gd name="T58" fmla="*/ 1524 w 4049"/>
              <a:gd name="T59" fmla="*/ 707 h 939"/>
              <a:gd name="T60" fmla="*/ 1524 w 4049"/>
              <a:gd name="T61" fmla="*/ 805 h 939"/>
              <a:gd name="T62" fmla="*/ 1597 w 4049"/>
              <a:gd name="T63" fmla="*/ 805 h 939"/>
              <a:gd name="T64" fmla="*/ 1618 w 4049"/>
              <a:gd name="T65" fmla="*/ 805 h 939"/>
              <a:gd name="T66" fmla="*/ 1784 w 4049"/>
              <a:gd name="T67" fmla="*/ 805 h 939"/>
              <a:gd name="T68" fmla="*/ 1906 w 4049"/>
              <a:gd name="T69" fmla="*/ 805 h 939"/>
              <a:gd name="T70" fmla="*/ 1943 w 4049"/>
              <a:gd name="T71" fmla="*/ 805 h 939"/>
              <a:gd name="T72" fmla="*/ 2033 w 4049"/>
              <a:gd name="T73" fmla="*/ 805 h 939"/>
              <a:gd name="T74" fmla="*/ 2052 w 4049"/>
              <a:gd name="T75" fmla="*/ 805 h 939"/>
              <a:gd name="T76" fmla="*/ 2252 w 4049"/>
              <a:gd name="T77" fmla="*/ 805 h 939"/>
              <a:gd name="T78" fmla="*/ 2252 w 4049"/>
              <a:gd name="T79" fmla="*/ 939 h 939"/>
              <a:gd name="T80" fmla="*/ 2290 w 4049"/>
              <a:gd name="T81" fmla="*/ 939 h 939"/>
              <a:gd name="T82" fmla="*/ 2337 w 4049"/>
              <a:gd name="T83" fmla="*/ 939 h 939"/>
              <a:gd name="T84" fmla="*/ 2398 w 4049"/>
              <a:gd name="T85" fmla="*/ 939 h 939"/>
              <a:gd name="T86" fmla="*/ 2479 w 4049"/>
              <a:gd name="T87" fmla="*/ 939 h 939"/>
              <a:gd name="T88" fmla="*/ 2661 w 4049"/>
              <a:gd name="T89" fmla="*/ 939 h 939"/>
              <a:gd name="T90" fmla="*/ 2867 w 4049"/>
              <a:gd name="T91" fmla="*/ 939 h 939"/>
              <a:gd name="T92" fmla="*/ 2976 w 4049"/>
              <a:gd name="T93" fmla="*/ 939 h 939"/>
              <a:gd name="T94" fmla="*/ 3089 w 4049"/>
              <a:gd name="T95" fmla="*/ 939 h 939"/>
              <a:gd name="T96" fmla="*/ 3118 w 4049"/>
              <a:gd name="T97" fmla="*/ 939 h 939"/>
              <a:gd name="T98" fmla="*/ 3399 w 4049"/>
              <a:gd name="T99" fmla="*/ 939 h 939"/>
              <a:gd name="T100" fmla="*/ 3473 w 4049"/>
              <a:gd name="T101" fmla="*/ 939 h 939"/>
              <a:gd name="T102" fmla="*/ 3548 w 4049"/>
              <a:gd name="T103" fmla="*/ 939 h 939"/>
              <a:gd name="T104" fmla="*/ 3640 w 4049"/>
              <a:gd name="T105" fmla="*/ 939 h 939"/>
              <a:gd name="T106" fmla="*/ 3683 w 4049"/>
              <a:gd name="T107" fmla="*/ 939 h 939"/>
              <a:gd name="T108" fmla="*/ 3809 w 4049"/>
              <a:gd name="T109" fmla="*/ 939 h 939"/>
              <a:gd name="T110" fmla="*/ 4032 w 4049"/>
              <a:gd name="T111" fmla="*/ 939 h 939"/>
              <a:gd name="T112" fmla="*/ 4049 w 4049"/>
              <a:gd name="T113" fmla="*/ 939 h 9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049" h="939">
                <a:moveTo>
                  <a:pt x="0" y="0"/>
                </a:moveTo>
                <a:lnTo>
                  <a:pt x="386" y="0"/>
                </a:lnTo>
                <a:lnTo>
                  <a:pt x="426" y="0"/>
                </a:lnTo>
                <a:lnTo>
                  <a:pt x="426" y="67"/>
                </a:lnTo>
                <a:lnTo>
                  <a:pt x="451" y="67"/>
                </a:lnTo>
                <a:lnTo>
                  <a:pt x="451" y="136"/>
                </a:lnTo>
                <a:lnTo>
                  <a:pt x="643" y="136"/>
                </a:lnTo>
                <a:lnTo>
                  <a:pt x="716" y="136"/>
                </a:lnTo>
                <a:lnTo>
                  <a:pt x="762" y="136"/>
                </a:lnTo>
                <a:lnTo>
                  <a:pt x="762" y="209"/>
                </a:lnTo>
                <a:lnTo>
                  <a:pt x="781" y="209"/>
                </a:lnTo>
                <a:lnTo>
                  <a:pt x="787" y="209"/>
                </a:lnTo>
                <a:lnTo>
                  <a:pt x="837" y="209"/>
                </a:lnTo>
                <a:lnTo>
                  <a:pt x="837" y="288"/>
                </a:lnTo>
                <a:lnTo>
                  <a:pt x="877" y="288"/>
                </a:lnTo>
                <a:lnTo>
                  <a:pt x="877" y="369"/>
                </a:lnTo>
                <a:lnTo>
                  <a:pt x="956" y="369"/>
                </a:lnTo>
                <a:lnTo>
                  <a:pt x="956" y="450"/>
                </a:lnTo>
                <a:lnTo>
                  <a:pt x="960" y="530"/>
                </a:lnTo>
                <a:lnTo>
                  <a:pt x="992" y="530"/>
                </a:lnTo>
                <a:lnTo>
                  <a:pt x="1056" y="530"/>
                </a:lnTo>
                <a:lnTo>
                  <a:pt x="1157" y="530"/>
                </a:lnTo>
                <a:lnTo>
                  <a:pt x="1206" y="530"/>
                </a:lnTo>
                <a:lnTo>
                  <a:pt x="1206" y="619"/>
                </a:lnTo>
                <a:lnTo>
                  <a:pt x="1244" y="619"/>
                </a:lnTo>
                <a:lnTo>
                  <a:pt x="1244" y="707"/>
                </a:lnTo>
                <a:lnTo>
                  <a:pt x="1336" y="707"/>
                </a:lnTo>
                <a:lnTo>
                  <a:pt x="1415" y="707"/>
                </a:lnTo>
                <a:lnTo>
                  <a:pt x="1461" y="707"/>
                </a:lnTo>
                <a:lnTo>
                  <a:pt x="1524" y="707"/>
                </a:lnTo>
                <a:lnTo>
                  <a:pt x="1524" y="805"/>
                </a:lnTo>
                <a:lnTo>
                  <a:pt x="1597" y="805"/>
                </a:lnTo>
                <a:lnTo>
                  <a:pt x="1618" y="805"/>
                </a:lnTo>
                <a:lnTo>
                  <a:pt x="1784" y="805"/>
                </a:lnTo>
                <a:lnTo>
                  <a:pt x="1906" y="805"/>
                </a:lnTo>
                <a:lnTo>
                  <a:pt x="1943" y="805"/>
                </a:lnTo>
                <a:lnTo>
                  <a:pt x="2033" y="805"/>
                </a:lnTo>
                <a:lnTo>
                  <a:pt x="2052" y="805"/>
                </a:lnTo>
                <a:lnTo>
                  <a:pt x="2252" y="805"/>
                </a:lnTo>
                <a:lnTo>
                  <a:pt x="2252" y="939"/>
                </a:lnTo>
                <a:lnTo>
                  <a:pt x="2290" y="939"/>
                </a:lnTo>
                <a:lnTo>
                  <a:pt x="2337" y="939"/>
                </a:lnTo>
                <a:lnTo>
                  <a:pt x="2398" y="939"/>
                </a:lnTo>
                <a:lnTo>
                  <a:pt x="2479" y="939"/>
                </a:lnTo>
                <a:lnTo>
                  <a:pt x="2661" y="939"/>
                </a:lnTo>
                <a:lnTo>
                  <a:pt x="2867" y="939"/>
                </a:lnTo>
                <a:lnTo>
                  <a:pt x="2976" y="939"/>
                </a:lnTo>
                <a:lnTo>
                  <a:pt x="3089" y="939"/>
                </a:lnTo>
                <a:lnTo>
                  <a:pt x="3118" y="939"/>
                </a:lnTo>
                <a:lnTo>
                  <a:pt x="3399" y="939"/>
                </a:lnTo>
                <a:lnTo>
                  <a:pt x="3473" y="939"/>
                </a:lnTo>
                <a:lnTo>
                  <a:pt x="3548" y="939"/>
                </a:lnTo>
                <a:lnTo>
                  <a:pt x="3640" y="939"/>
                </a:lnTo>
                <a:lnTo>
                  <a:pt x="3683" y="939"/>
                </a:lnTo>
                <a:lnTo>
                  <a:pt x="3809" y="939"/>
                </a:lnTo>
                <a:lnTo>
                  <a:pt x="4032" y="939"/>
                </a:lnTo>
                <a:lnTo>
                  <a:pt x="4049" y="939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5" name="Freeform 29">
            <a:extLst>
              <a:ext uri="{FF2B5EF4-FFF2-40B4-BE49-F238E27FC236}">
                <a16:creationId xmlns:a16="http://schemas.microsoft.com/office/drawing/2014/main" id="{6E7332D1-8C9F-48C4-B777-1242CA1D673E}"/>
              </a:ext>
            </a:extLst>
          </p:cNvPr>
          <p:cNvSpPr>
            <a:spLocks/>
          </p:cNvSpPr>
          <p:nvPr/>
        </p:nvSpPr>
        <p:spPr bwMode="auto">
          <a:xfrm>
            <a:off x="1107920" y="2363543"/>
            <a:ext cx="3789363" cy="1543050"/>
          </a:xfrm>
          <a:custGeom>
            <a:avLst/>
            <a:gdLst>
              <a:gd name="T0" fmla="*/ 0 w 4773"/>
              <a:gd name="T1" fmla="*/ 0 h 1942"/>
              <a:gd name="T2" fmla="*/ 336 w 4773"/>
              <a:gd name="T3" fmla="*/ 0 h 1942"/>
              <a:gd name="T4" fmla="*/ 336 w 4773"/>
              <a:gd name="T5" fmla="*/ 79 h 1942"/>
              <a:gd name="T6" fmla="*/ 516 w 4773"/>
              <a:gd name="T7" fmla="*/ 79 h 1942"/>
              <a:gd name="T8" fmla="*/ 651 w 4773"/>
              <a:gd name="T9" fmla="*/ 79 h 1942"/>
              <a:gd name="T10" fmla="*/ 652 w 4773"/>
              <a:gd name="T11" fmla="*/ 159 h 1942"/>
              <a:gd name="T12" fmla="*/ 666 w 4773"/>
              <a:gd name="T13" fmla="*/ 159 h 1942"/>
              <a:gd name="T14" fmla="*/ 666 w 4773"/>
              <a:gd name="T15" fmla="*/ 240 h 1942"/>
              <a:gd name="T16" fmla="*/ 724 w 4773"/>
              <a:gd name="T17" fmla="*/ 240 h 1942"/>
              <a:gd name="T18" fmla="*/ 812 w 4773"/>
              <a:gd name="T19" fmla="*/ 240 h 1942"/>
              <a:gd name="T20" fmla="*/ 812 w 4773"/>
              <a:gd name="T21" fmla="*/ 325 h 1942"/>
              <a:gd name="T22" fmla="*/ 950 w 4773"/>
              <a:gd name="T23" fmla="*/ 325 h 1942"/>
              <a:gd name="T24" fmla="*/ 950 w 4773"/>
              <a:gd name="T25" fmla="*/ 409 h 1942"/>
              <a:gd name="T26" fmla="*/ 992 w 4773"/>
              <a:gd name="T27" fmla="*/ 409 h 1942"/>
              <a:gd name="T28" fmla="*/ 992 w 4773"/>
              <a:gd name="T29" fmla="*/ 494 h 1942"/>
              <a:gd name="T30" fmla="*/ 1006 w 4773"/>
              <a:gd name="T31" fmla="*/ 494 h 1942"/>
              <a:gd name="T32" fmla="*/ 1006 w 4773"/>
              <a:gd name="T33" fmla="*/ 576 h 1942"/>
              <a:gd name="T34" fmla="*/ 1033 w 4773"/>
              <a:gd name="T35" fmla="*/ 576 h 1942"/>
              <a:gd name="T36" fmla="*/ 1209 w 4773"/>
              <a:gd name="T37" fmla="*/ 576 h 1942"/>
              <a:gd name="T38" fmla="*/ 1246 w 4773"/>
              <a:gd name="T39" fmla="*/ 576 h 1942"/>
              <a:gd name="T40" fmla="*/ 1273 w 4773"/>
              <a:gd name="T41" fmla="*/ 576 h 1942"/>
              <a:gd name="T42" fmla="*/ 1476 w 4773"/>
              <a:gd name="T43" fmla="*/ 576 h 1942"/>
              <a:gd name="T44" fmla="*/ 1499 w 4773"/>
              <a:gd name="T45" fmla="*/ 576 h 1942"/>
              <a:gd name="T46" fmla="*/ 1540 w 4773"/>
              <a:gd name="T47" fmla="*/ 576 h 1942"/>
              <a:gd name="T48" fmla="*/ 1540 w 4773"/>
              <a:gd name="T49" fmla="*/ 680 h 1942"/>
              <a:gd name="T50" fmla="*/ 1576 w 4773"/>
              <a:gd name="T51" fmla="*/ 680 h 1942"/>
              <a:gd name="T52" fmla="*/ 1595 w 4773"/>
              <a:gd name="T53" fmla="*/ 680 h 1942"/>
              <a:gd name="T54" fmla="*/ 1595 w 4773"/>
              <a:gd name="T55" fmla="*/ 786 h 1942"/>
              <a:gd name="T56" fmla="*/ 1607 w 4773"/>
              <a:gd name="T57" fmla="*/ 786 h 1942"/>
              <a:gd name="T58" fmla="*/ 1661 w 4773"/>
              <a:gd name="T59" fmla="*/ 786 h 1942"/>
              <a:gd name="T60" fmla="*/ 1791 w 4773"/>
              <a:gd name="T61" fmla="*/ 786 h 1942"/>
              <a:gd name="T62" fmla="*/ 1935 w 4773"/>
              <a:gd name="T63" fmla="*/ 786 h 1942"/>
              <a:gd name="T64" fmla="*/ 1935 w 4773"/>
              <a:gd name="T65" fmla="*/ 909 h 1942"/>
              <a:gd name="T66" fmla="*/ 1985 w 4773"/>
              <a:gd name="T67" fmla="*/ 909 h 1942"/>
              <a:gd name="T68" fmla="*/ 2008 w 4773"/>
              <a:gd name="T69" fmla="*/ 909 h 1942"/>
              <a:gd name="T70" fmla="*/ 2029 w 4773"/>
              <a:gd name="T71" fmla="*/ 909 h 1942"/>
              <a:gd name="T72" fmla="*/ 2056 w 4773"/>
              <a:gd name="T73" fmla="*/ 909 h 1942"/>
              <a:gd name="T74" fmla="*/ 2056 w 4773"/>
              <a:gd name="T75" fmla="*/ 1062 h 1942"/>
              <a:gd name="T76" fmla="*/ 2185 w 4773"/>
              <a:gd name="T77" fmla="*/ 1062 h 1942"/>
              <a:gd name="T78" fmla="*/ 2206 w 4773"/>
              <a:gd name="T79" fmla="*/ 1062 h 1942"/>
              <a:gd name="T80" fmla="*/ 2206 w 4773"/>
              <a:gd name="T81" fmla="*/ 1226 h 1942"/>
              <a:gd name="T82" fmla="*/ 2394 w 4773"/>
              <a:gd name="T83" fmla="*/ 1226 h 1942"/>
              <a:gd name="T84" fmla="*/ 2529 w 4773"/>
              <a:gd name="T85" fmla="*/ 1226 h 1942"/>
              <a:gd name="T86" fmla="*/ 2580 w 4773"/>
              <a:gd name="T87" fmla="*/ 1226 h 1942"/>
              <a:gd name="T88" fmla="*/ 2580 w 4773"/>
              <a:gd name="T89" fmla="*/ 1418 h 1942"/>
              <a:gd name="T90" fmla="*/ 2703 w 4773"/>
              <a:gd name="T91" fmla="*/ 1418 h 1942"/>
              <a:gd name="T92" fmla="*/ 2872 w 4773"/>
              <a:gd name="T93" fmla="*/ 1418 h 1942"/>
              <a:gd name="T94" fmla="*/ 3036 w 4773"/>
              <a:gd name="T95" fmla="*/ 1418 h 1942"/>
              <a:gd name="T96" fmla="*/ 3036 w 4773"/>
              <a:gd name="T97" fmla="*/ 1660 h 1942"/>
              <a:gd name="T98" fmla="*/ 3464 w 4773"/>
              <a:gd name="T99" fmla="*/ 1660 h 1942"/>
              <a:gd name="T100" fmla="*/ 3635 w 4773"/>
              <a:gd name="T101" fmla="*/ 1660 h 1942"/>
              <a:gd name="T102" fmla="*/ 3635 w 4773"/>
              <a:gd name="T103" fmla="*/ 1942 h 1942"/>
              <a:gd name="T104" fmla="*/ 3669 w 4773"/>
              <a:gd name="T105" fmla="*/ 1942 h 1942"/>
              <a:gd name="T106" fmla="*/ 3884 w 4773"/>
              <a:gd name="T107" fmla="*/ 1942 h 1942"/>
              <a:gd name="T108" fmla="*/ 4253 w 4773"/>
              <a:gd name="T109" fmla="*/ 1942 h 1942"/>
              <a:gd name="T110" fmla="*/ 4612 w 4773"/>
              <a:gd name="T111" fmla="*/ 1942 h 1942"/>
              <a:gd name="T112" fmla="*/ 4773 w 4773"/>
              <a:gd name="T113" fmla="*/ 1942 h 19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4773" h="1942">
                <a:moveTo>
                  <a:pt x="0" y="0"/>
                </a:moveTo>
                <a:lnTo>
                  <a:pt x="336" y="0"/>
                </a:lnTo>
                <a:lnTo>
                  <a:pt x="336" y="79"/>
                </a:lnTo>
                <a:lnTo>
                  <a:pt x="516" y="79"/>
                </a:lnTo>
                <a:lnTo>
                  <a:pt x="651" y="79"/>
                </a:lnTo>
                <a:lnTo>
                  <a:pt x="652" y="159"/>
                </a:lnTo>
                <a:lnTo>
                  <a:pt x="666" y="159"/>
                </a:lnTo>
                <a:lnTo>
                  <a:pt x="666" y="240"/>
                </a:lnTo>
                <a:lnTo>
                  <a:pt x="724" y="240"/>
                </a:lnTo>
                <a:lnTo>
                  <a:pt x="812" y="240"/>
                </a:lnTo>
                <a:lnTo>
                  <a:pt x="812" y="325"/>
                </a:lnTo>
                <a:lnTo>
                  <a:pt x="950" y="325"/>
                </a:lnTo>
                <a:lnTo>
                  <a:pt x="950" y="409"/>
                </a:lnTo>
                <a:lnTo>
                  <a:pt x="992" y="409"/>
                </a:lnTo>
                <a:lnTo>
                  <a:pt x="992" y="494"/>
                </a:lnTo>
                <a:lnTo>
                  <a:pt x="1006" y="494"/>
                </a:lnTo>
                <a:lnTo>
                  <a:pt x="1006" y="576"/>
                </a:lnTo>
                <a:lnTo>
                  <a:pt x="1033" y="576"/>
                </a:lnTo>
                <a:lnTo>
                  <a:pt x="1209" y="576"/>
                </a:lnTo>
                <a:lnTo>
                  <a:pt x="1246" y="576"/>
                </a:lnTo>
                <a:lnTo>
                  <a:pt x="1273" y="576"/>
                </a:lnTo>
                <a:lnTo>
                  <a:pt x="1476" y="576"/>
                </a:lnTo>
                <a:lnTo>
                  <a:pt x="1499" y="576"/>
                </a:lnTo>
                <a:lnTo>
                  <a:pt x="1540" y="576"/>
                </a:lnTo>
                <a:lnTo>
                  <a:pt x="1540" y="680"/>
                </a:lnTo>
                <a:lnTo>
                  <a:pt x="1576" y="680"/>
                </a:lnTo>
                <a:lnTo>
                  <a:pt x="1595" y="680"/>
                </a:lnTo>
                <a:lnTo>
                  <a:pt x="1595" y="786"/>
                </a:lnTo>
                <a:lnTo>
                  <a:pt x="1607" y="786"/>
                </a:lnTo>
                <a:lnTo>
                  <a:pt x="1661" y="786"/>
                </a:lnTo>
                <a:lnTo>
                  <a:pt x="1791" y="786"/>
                </a:lnTo>
                <a:lnTo>
                  <a:pt x="1935" y="786"/>
                </a:lnTo>
                <a:lnTo>
                  <a:pt x="1935" y="909"/>
                </a:lnTo>
                <a:lnTo>
                  <a:pt x="1985" y="909"/>
                </a:lnTo>
                <a:lnTo>
                  <a:pt x="2008" y="909"/>
                </a:lnTo>
                <a:lnTo>
                  <a:pt x="2029" y="909"/>
                </a:lnTo>
                <a:lnTo>
                  <a:pt x="2056" y="909"/>
                </a:lnTo>
                <a:lnTo>
                  <a:pt x="2056" y="1062"/>
                </a:lnTo>
                <a:lnTo>
                  <a:pt x="2185" y="1062"/>
                </a:lnTo>
                <a:lnTo>
                  <a:pt x="2206" y="1062"/>
                </a:lnTo>
                <a:lnTo>
                  <a:pt x="2206" y="1226"/>
                </a:lnTo>
                <a:lnTo>
                  <a:pt x="2394" y="1226"/>
                </a:lnTo>
                <a:lnTo>
                  <a:pt x="2529" y="1226"/>
                </a:lnTo>
                <a:lnTo>
                  <a:pt x="2580" y="1226"/>
                </a:lnTo>
                <a:lnTo>
                  <a:pt x="2580" y="1418"/>
                </a:lnTo>
                <a:lnTo>
                  <a:pt x="2703" y="1418"/>
                </a:lnTo>
                <a:lnTo>
                  <a:pt x="2872" y="1418"/>
                </a:lnTo>
                <a:lnTo>
                  <a:pt x="3036" y="1418"/>
                </a:lnTo>
                <a:lnTo>
                  <a:pt x="3036" y="1660"/>
                </a:lnTo>
                <a:lnTo>
                  <a:pt x="3464" y="1660"/>
                </a:lnTo>
                <a:lnTo>
                  <a:pt x="3635" y="1660"/>
                </a:lnTo>
                <a:lnTo>
                  <a:pt x="3635" y="1942"/>
                </a:lnTo>
                <a:lnTo>
                  <a:pt x="3669" y="1942"/>
                </a:lnTo>
                <a:lnTo>
                  <a:pt x="3884" y="1942"/>
                </a:lnTo>
                <a:lnTo>
                  <a:pt x="4253" y="1942"/>
                </a:lnTo>
                <a:lnTo>
                  <a:pt x="4612" y="1942"/>
                </a:lnTo>
                <a:lnTo>
                  <a:pt x="4773" y="1942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Freeform 85">
            <a:extLst>
              <a:ext uri="{FF2B5EF4-FFF2-40B4-BE49-F238E27FC236}">
                <a16:creationId xmlns:a16="http://schemas.microsoft.com/office/drawing/2014/main" id="{66B83BB0-EF31-4D87-8C11-D3DC85A91CC4}"/>
              </a:ext>
            </a:extLst>
          </p:cNvPr>
          <p:cNvSpPr>
            <a:spLocks/>
          </p:cNvSpPr>
          <p:nvPr/>
        </p:nvSpPr>
        <p:spPr bwMode="auto">
          <a:xfrm>
            <a:off x="7292575" y="2352119"/>
            <a:ext cx="3302000" cy="1011237"/>
          </a:xfrm>
          <a:custGeom>
            <a:avLst/>
            <a:gdLst>
              <a:gd name="T0" fmla="*/ 0 w 4158"/>
              <a:gd name="T1" fmla="*/ 0 h 1276"/>
              <a:gd name="T2" fmla="*/ 205 w 4158"/>
              <a:gd name="T3" fmla="*/ 0 h 1276"/>
              <a:gd name="T4" fmla="*/ 205 w 4158"/>
              <a:gd name="T5" fmla="*/ 67 h 1276"/>
              <a:gd name="T6" fmla="*/ 236 w 4158"/>
              <a:gd name="T7" fmla="*/ 67 h 1276"/>
              <a:gd name="T8" fmla="*/ 236 w 4158"/>
              <a:gd name="T9" fmla="*/ 133 h 1276"/>
              <a:gd name="T10" fmla="*/ 276 w 4158"/>
              <a:gd name="T11" fmla="*/ 133 h 1276"/>
              <a:gd name="T12" fmla="*/ 276 w 4158"/>
              <a:gd name="T13" fmla="*/ 198 h 1276"/>
              <a:gd name="T14" fmla="*/ 293 w 4158"/>
              <a:gd name="T15" fmla="*/ 198 h 1276"/>
              <a:gd name="T16" fmla="*/ 293 w 4158"/>
              <a:gd name="T17" fmla="*/ 265 h 1276"/>
              <a:gd name="T18" fmla="*/ 311 w 4158"/>
              <a:gd name="T19" fmla="*/ 265 h 1276"/>
              <a:gd name="T20" fmla="*/ 311 w 4158"/>
              <a:gd name="T21" fmla="*/ 331 h 1276"/>
              <a:gd name="T22" fmla="*/ 332 w 4158"/>
              <a:gd name="T23" fmla="*/ 331 h 1276"/>
              <a:gd name="T24" fmla="*/ 332 w 4158"/>
              <a:gd name="T25" fmla="*/ 398 h 1276"/>
              <a:gd name="T26" fmla="*/ 395 w 4158"/>
              <a:gd name="T27" fmla="*/ 398 h 1276"/>
              <a:gd name="T28" fmla="*/ 449 w 4158"/>
              <a:gd name="T29" fmla="*/ 398 h 1276"/>
              <a:gd name="T30" fmla="*/ 449 w 4158"/>
              <a:gd name="T31" fmla="*/ 465 h 1276"/>
              <a:gd name="T32" fmla="*/ 451 w 4158"/>
              <a:gd name="T33" fmla="*/ 532 h 1276"/>
              <a:gd name="T34" fmla="*/ 459 w 4158"/>
              <a:gd name="T35" fmla="*/ 532 h 1276"/>
              <a:gd name="T36" fmla="*/ 459 w 4158"/>
              <a:gd name="T37" fmla="*/ 599 h 1276"/>
              <a:gd name="T38" fmla="*/ 470 w 4158"/>
              <a:gd name="T39" fmla="*/ 667 h 1276"/>
              <a:gd name="T40" fmla="*/ 660 w 4158"/>
              <a:gd name="T41" fmla="*/ 667 h 1276"/>
              <a:gd name="T42" fmla="*/ 664 w 4158"/>
              <a:gd name="T43" fmla="*/ 736 h 1276"/>
              <a:gd name="T44" fmla="*/ 716 w 4158"/>
              <a:gd name="T45" fmla="*/ 736 h 1276"/>
              <a:gd name="T46" fmla="*/ 716 w 4158"/>
              <a:gd name="T47" fmla="*/ 807 h 1276"/>
              <a:gd name="T48" fmla="*/ 733 w 4158"/>
              <a:gd name="T49" fmla="*/ 807 h 1276"/>
              <a:gd name="T50" fmla="*/ 774 w 4158"/>
              <a:gd name="T51" fmla="*/ 807 h 1276"/>
              <a:gd name="T52" fmla="*/ 774 w 4158"/>
              <a:gd name="T53" fmla="*/ 878 h 1276"/>
              <a:gd name="T54" fmla="*/ 801 w 4158"/>
              <a:gd name="T55" fmla="*/ 878 h 1276"/>
              <a:gd name="T56" fmla="*/ 808 w 4158"/>
              <a:gd name="T57" fmla="*/ 878 h 1276"/>
              <a:gd name="T58" fmla="*/ 900 w 4158"/>
              <a:gd name="T59" fmla="*/ 878 h 1276"/>
              <a:gd name="T60" fmla="*/ 1018 w 4158"/>
              <a:gd name="T61" fmla="*/ 878 h 1276"/>
              <a:gd name="T62" fmla="*/ 1083 w 4158"/>
              <a:gd name="T63" fmla="*/ 878 h 1276"/>
              <a:gd name="T64" fmla="*/ 1152 w 4158"/>
              <a:gd name="T65" fmla="*/ 878 h 1276"/>
              <a:gd name="T66" fmla="*/ 1152 w 4158"/>
              <a:gd name="T67" fmla="*/ 966 h 1276"/>
              <a:gd name="T68" fmla="*/ 1189 w 4158"/>
              <a:gd name="T69" fmla="*/ 966 h 1276"/>
              <a:gd name="T70" fmla="*/ 1371 w 4158"/>
              <a:gd name="T71" fmla="*/ 966 h 1276"/>
              <a:gd name="T72" fmla="*/ 1454 w 4158"/>
              <a:gd name="T73" fmla="*/ 966 h 1276"/>
              <a:gd name="T74" fmla="*/ 1640 w 4158"/>
              <a:gd name="T75" fmla="*/ 966 h 1276"/>
              <a:gd name="T76" fmla="*/ 1652 w 4158"/>
              <a:gd name="T77" fmla="*/ 1072 h 1276"/>
              <a:gd name="T78" fmla="*/ 1661 w 4158"/>
              <a:gd name="T79" fmla="*/ 1072 h 1276"/>
              <a:gd name="T80" fmla="*/ 1957 w 4158"/>
              <a:gd name="T81" fmla="*/ 1072 h 1276"/>
              <a:gd name="T82" fmla="*/ 1995 w 4158"/>
              <a:gd name="T83" fmla="*/ 1072 h 1276"/>
              <a:gd name="T84" fmla="*/ 2088 w 4158"/>
              <a:gd name="T85" fmla="*/ 1072 h 1276"/>
              <a:gd name="T86" fmla="*/ 2109 w 4158"/>
              <a:gd name="T87" fmla="*/ 1072 h 1276"/>
              <a:gd name="T88" fmla="*/ 2353 w 4158"/>
              <a:gd name="T89" fmla="*/ 1072 h 1276"/>
              <a:gd name="T90" fmla="*/ 2401 w 4158"/>
              <a:gd name="T91" fmla="*/ 1072 h 1276"/>
              <a:gd name="T92" fmla="*/ 2462 w 4158"/>
              <a:gd name="T93" fmla="*/ 1072 h 1276"/>
              <a:gd name="T94" fmla="*/ 2545 w 4158"/>
              <a:gd name="T95" fmla="*/ 1072 h 1276"/>
              <a:gd name="T96" fmla="*/ 2733 w 4158"/>
              <a:gd name="T97" fmla="*/ 1072 h 1276"/>
              <a:gd name="T98" fmla="*/ 3006 w 4158"/>
              <a:gd name="T99" fmla="*/ 1072 h 1276"/>
              <a:gd name="T100" fmla="*/ 3006 w 4158"/>
              <a:gd name="T101" fmla="*/ 1276 h 1276"/>
              <a:gd name="T102" fmla="*/ 3056 w 4158"/>
              <a:gd name="T103" fmla="*/ 1276 h 1276"/>
              <a:gd name="T104" fmla="*/ 3171 w 4158"/>
              <a:gd name="T105" fmla="*/ 1276 h 1276"/>
              <a:gd name="T106" fmla="*/ 3202 w 4158"/>
              <a:gd name="T107" fmla="*/ 1276 h 1276"/>
              <a:gd name="T108" fmla="*/ 3567 w 4158"/>
              <a:gd name="T109" fmla="*/ 1276 h 1276"/>
              <a:gd name="T110" fmla="*/ 3643 w 4158"/>
              <a:gd name="T111" fmla="*/ 1276 h 1276"/>
              <a:gd name="T112" fmla="*/ 3716 w 4158"/>
              <a:gd name="T113" fmla="*/ 1276 h 1276"/>
              <a:gd name="T114" fmla="*/ 3780 w 4158"/>
              <a:gd name="T115" fmla="*/ 1276 h 1276"/>
              <a:gd name="T116" fmla="*/ 3912 w 4158"/>
              <a:gd name="T117" fmla="*/ 1276 h 1276"/>
              <a:gd name="T118" fmla="*/ 4149 w 4158"/>
              <a:gd name="T119" fmla="*/ 1276 h 1276"/>
              <a:gd name="T120" fmla="*/ 4158 w 4158"/>
              <a:gd name="T121" fmla="*/ 1276 h 12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4158" h="1276">
                <a:moveTo>
                  <a:pt x="0" y="0"/>
                </a:moveTo>
                <a:lnTo>
                  <a:pt x="205" y="0"/>
                </a:lnTo>
                <a:lnTo>
                  <a:pt x="205" y="67"/>
                </a:lnTo>
                <a:lnTo>
                  <a:pt x="236" y="67"/>
                </a:lnTo>
                <a:lnTo>
                  <a:pt x="236" y="133"/>
                </a:lnTo>
                <a:lnTo>
                  <a:pt x="276" y="133"/>
                </a:lnTo>
                <a:lnTo>
                  <a:pt x="276" y="198"/>
                </a:lnTo>
                <a:lnTo>
                  <a:pt x="293" y="198"/>
                </a:lnTo>
                <a:lnTo>
                  <a:pt x="293" y="265"/>
                </a:lnTo>
                <a:lnTo>
                  <a:pt x="311" y="265"/>
                </a:lnTo>
                <a:lnTo>
                  <a:pt x="311" y="331"/>
                </a:lnTo>
                <a:lnTo>
                  <a:pt x="332" y="331"/>
                </a:lnTo>
                <a:lnTo>
                  <a:pt x="332" y="398"/>
                </a:lnTo>
                <a:lnTo>
                  <a:pt x="395" y="398"/>
                </a:lnTo>
                <a:lnTo>
                  <a:pt x="449" y="398"/>
                </a:lnTo>
                <a:lnTo>
                  <a:pt x="449" y="465"/>
                </a:lnTo>
                <a:lnTo>
                  <a:pt x="451" y="532"/>
                </a:lnTo>
                <a:lnTo>
                  <a:pt x="459" y="532"/>
                </a:lnTo>
                <a:lnTo>
                  <a:pt x="459" y="599"/>
                </a:lnTo>
                <a:lnTo>
                  <a:pt x="470" y="667"/>
                </a:lnTo>
                <a:lnTo>
                  <a:pt x="660" y="667"/>
                </a:lnTo>
                <a:lnTo>
                  <a:pt x="664" y="736"/>
                </a:lnTo>
                <a:lnTo>
                  <a:pt x="716" y="736"/>
                </a:lnTo>
                <a:lnTo>
                  <a:pt x="716" y="807"/>
                </a:lnTo>
                <a:lnTo>
                  <a:pt x="733" y="807"/>
                </a:lnTo>
                <a:lnTo>
                  <a:pt x="774" y="807"/>
                </a:lnTo>
                <a:lnTo>
                  <a:pt x="774" y="878"/>
                </a:lnTo>
                <a:lnTo>
                  <a:pt x="801" y="878"/>
                </a:lnTo>
                <a:lnTo>
                  <a:pt x="808" y="878"/>
                </a:lnTo>
                <a:lnTo>
                  <a:pt x="900" y="878"/>
                </a:lnTo>
                <a:lnTo>
                  <a:pt x="1018" y="878"/>
                </a:lnTo>
                <a:lnTo>
                  <a:pt x="1083" y="878"/>
                </a:lnTo>
                <a:lnTo>
                  <a:pt x="1152" y="878"/>
                </a:lnTo>
                <a:lnTo>
                  <a:pt x="1152" y="966"/>
                </a:lnTo>
                <a:lnTo>
                  <a:pt x="1189" y="966"/>
                </a:lnTo>
                <a:lnTo>
                  <a:pt x="1371" y="966"/>
                </a:lnTo>
                <a:lnTo>
                  <a:pt x="1454" y="966"/>
                </a:lnTo>
                <a:lnTo>
                  <a:pt x="1640" y="966"/>
                </a:lnTo>
                <a:lnTo>
                  <a:pt x="1652" y="1072"/>
                </a:lnTo>
                <a:lnTo>
                  <a:pt x="1661" y="1072"/>
                </a:lnTo>
                <a:lnTo>
                  <a:pt x="1957" y="1072"/>
                </a:lnTo>
                <a:lnTo>
                  <a:pt x="1995" y="1072"/>
                </a:lnTo>
                <a:lnTo>
                  <a:pt x="2088" y="1072"/>
                </a:lnTo>
                <a:lnTo>
                  <a:pt x="2109" y="1072"/>
                </a:lnTo>
                <a:lnTo>
                  <a:pt x="2353" y="1072"/>
                </a:lnTo>
                <a:lnTo>
                  <a:pt x="2401" y="1072"/>
                </a:lnTo>
                <a:lnTo>
                  <a:pt x="2462" y="1072"/>
                </a:lnTo>
                <a:lnTo>
                  <a:pt x="2545" y="1072"/>
                </a:lnTo>
                <a:lnTo>
                  <a:pt x="2733" y="1072"/>
                </a:lnTo>
                <a:lnTo>
                  <a:pt x="3006" y="1072"/>
                </a:lnTo>
                <a:lnTo>
                  <a:pt x="3006" y="1276"/>
                </a:lnTo>
                <a:lnTo>
                  <a:pt x="3056" y="1276"/>
                </a:lnTo>
                <a:lnTo>
                  <a:pt x="3171" y="1276"/>
                </a:lnTo>
                <a:lnTo>
                  <a:pt x="3202" y="1276"/>
                </a:lnTo>
                <a:lnTo>
                  <a:pt x="3567" y="1276"/>
                </a:lnTo>
                <a:lnTo>
                  <a:pt x="3643" y="1276"/>
                </a:lnTo>
                <a:lnTo>
                  <a:pt x="3716" y="1276"/>
                </a:lnTo>
                <a:lnTo>
                  <a:pt x="3780" y="1276"/>
                </a:lnTo>
                <a:lnTo>
                  <a:pt x="3912" y="1276"/>
                </a:lnTo>
                <a:lnTo>
                  <a:pt x="4149" y="1276"/>
                </a:lnTo>
                <a:lnTo>
                  <a:pt x="4158" y="1276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8" name="Freeform 86">
            <a:extLst>
              <a:ext uri="{FF2B5EF4-FFF2-40B4-BE49-F238E27FC236}">
                <a16:creationId xmlns:a16="http://schemas.microsoft.com/office/drawing/2014/main" id="{28ED80A2-D73B-4821-BD8B-785FF89E4601}"/>
              </a:ext>
            </a:extLst>
          </p:cNvPr>
          <p:cNvSpPr>
            <a:spLocks/>
          </p:cNvSpPr>
          <p:nvPr/>
        </p:nvSpPr>
        <p:spPr bwMode="auto">
          <a:xfrm>
            <a:off x="7292575" y="2352119"/>
            <a:ext cx="3760788" cy="1295400"/>
          </a:xfrm>
          <a:custGeom>
            <a:avLst/>
            <a:gdLst>
              <a:gd name="T0" fmla="*/ 0 w 4736"/>
              <a:gd name="T1" fmla="*/ 0 h 1633"/>
              <a:gd name="T2" fmla="*/ 140 w 4736"/>
              <a:gd name="T3" fmla="*/ 0 h 1633"/>
              <a:gd name="T4" fmla="*/ 140 w 4736"/>
              <a:gd name="T5" fmla="*/ 77 h 1633"/>
              <a:gd name="T6" fmla="*/ 165 w 4736"/>
              <a:gd name="T7" fmla="*/ 77 h 1633"/>
              <a:gd name="T8" fmla="*/ 165 w 4736"/>
              <a:gd name="T9" fmla="*/ 154 h 1633"/>
              <a:gd name="T10" fmla="*/ 272 w 4736"/>
              <a:gd name="T11" fmla="*/ 154 h 1633"/>
              <a:gd name="T12" fmla="*/ 272 w 4736"/>
              <a:gd name="T13" fmla="*/ 231 h 1633"/>
              <a:gd name="T14" fmla="*/ 305 w 4736"/>
              <a:gd name="T15" fmla="*/ 231 h 1633"/>
              <a:gd name="T16" fmla="*/ 305 w 4736"/>
              <a:gd name="T17" fmla="*/ 308 h 1633"/>
              <a:gd name="T18" fmla="*/ 334 w 4736"/>
              <a:gd name="T19" fmla="*/ 308 h 1633"/>
              <a:gd name="T20" fmla="*/ 334 w 4736"/>
              <a:gd name="T21" fmla="*/ 384 h 1633"/>
              <a:gd name="T22" fmla="*/ 359 w 4736"/>
              <a:gd name="T23" fmla="*/ 384 h 1633"/>
              <a:gd name="T24" fmla="*/ 359 w 4736"/>
              <a:gd name="T25" fmla="*/ 461 h 1633"/>
              <a:gd name="T26" fmla="*/ 399 w 4736"/>
              <a:gd name="T27" fmla="*/ 461 h 1633"/>
              <a:gd name="T28" fmla="*/ 399 w 4736"/>
              <a:gd name="T29" fmla="*/ 538 h 1633"/>
              <a:gd name="T30" fmla="*/ 416 w 4736"/>
              <a:gd name="T31" fmla="*/ 615 h 1633"/>
              <a:gd name="T32" fmla="*/ 436 w 4736"/>
              <a:gd name="T33" fmla="*/ 615 h 1633"/>
              <a:gd name="T34" fmla="*/ 436 w 4736"/>
              <a:gd name="T35" fmla="*/ 692 h 1633"/>
              <a:gd name="T36" fmla="*/ 487 w 4736"/>
              <a:gd name="T37" fmla="*/ 692 h 1633"/>
              <a:gd name="T38" fmla="*/ 487 w 4736"/>
              <a:gd name="T39" fmla="*/ 768 h 1633"/>
              <a:gd name="T40" fmla="*/ 491 w 4736"/>
              <a:gd name="T41" fmla="*/ 768 h 1633"/>
              <a:gd name="T42" fmla="*/ 491 w 4736"/>
              <a:gd name="T43" fmla="*/ 845 h 1633"/>
              <a:gd name="T44" fmla="*/ 495 w 4736"/>
              <a:gd name="T45" fmla="*/ 922 h 1633"/>
              <a:gd name="T46" fmla="*/ 530 w 4736"/>
              <a:gd name="T47" fmla="*/ 922 h 1633"/>
              <a:gd name="T48" fmla="*/ 616 w 4736"/>
              <a:gd name="T49" fmla="*/ 922 h 1633"/>
              <a:gd name="T50" fmla="*/ 616 w 4736"/>
              <a:gd name="T51" fmla="*/ 1001 h 1633"/>
              <a:gd name="T52" fmla="*/ 622 w 4736"/>
              <a:gd name="T53" fmla="*/ 1001 h 1633"/>
              <a:gd name="T54" fmla="*/ 622 w 4736"/>
              <a:gd name="T55" fmla="*/ 1080 h 1633"/>
              <a:gd name="T56" fmla="*/ 666 w 4736"/>
              <a:gd name="T57" fmla="*/ 1080 h 1633"/>
              <a:gd name="T58" fmla="*/ 676 w 4736"/>
              <a:gd name="T59" fmla="*/ 1162 h 1633"/>
              <a:gd name="T60" fmla="*/ 687 w 4736"/>
              <a:gd name="T61" fmla="*/ 1162 h 1633"/>
              <a:gd name="T62" fmla="*/ 687 w 4736"/>
              <a:gd name="T63" fmla="*/ 1245 h 1633"/>
              <a:gd name="T64" fmla="*/ 706 w 4736"/>
              <a:gd name="T65" fmla="*/ 1245 h 1633"/>
              <a:gd name="T66" fmla="*/ 706 w 4736"/>
              <a:gd name="T67" fmla="*/ 1327 h 1633"/>
              <a:gd name="T68" fmla="*/ 1515 w 4736"/>
              <a:gd name="T69" fmla="*/ 1327 h 1633"/>
              <a:gd name="T70" fmla="*/ 1538 w 4736"/>
              <a:gd name="T71" fmla="*/ 1327 h 1633"/>
              <a:gd name="T72" fmla="*/ 1617 w 4736"/>
              <a:gd name="T73" fmla="*/ 1327 h 1633"/>
              <a:gd name="T74" fmla="*/ 1703 w 4736"/>
              <a:gd name="T75" fmla="*/ 1327 h 1633"/>
              <a:gd name="T76" fmla="*/ 1753 w 4736"/>
              <a:gd name="T77" fmla="*/ 1327 h 1633"/>
              <a:gd name="T78" fmla="*/ 1753 w 4736"/>
              <a:gd name="T79" fmla="*/ 1425 h 1633"/>
              <a:gd name="T80" fmla="*/ 1838 w 4736"/>
              <a:gd name="T81" fmla="*/ 1425 h 1633"/>
              <a:gd name="T82" fmla="*/ 2038 w 4736"/>
              <a:gd name="T83" fmla="*/ 1425 h 1633"/>
              <a:gd name="T84" fmla="*/ 2063 w 4736"/>
              <a:gd name="T85" fmla="*/ 1425 h 1633"/>
              <a:gd name="T86" fmla="*/ 2082 w 4736"/>
              <a:gd name="T87" fmla="*/ 1425 h 1633"/>
              <a:gd name="T88" fmla="*/ 2243 w 4736"/>
              <a:gd name="T89" fmla="*/ 1425 h 1633"/>
              <a:gd name="T90" fmla="*/ 2441 w 4736"/>
              <a:gd name="T91" fmla="*/ 1425 h 1633"/>
              <a:gd name="T92" fmla="*/ 2458 w 4736"/>
              <a:gd name="T93" fmla="*/ 1425 h 1633"/>
              <a:gd name="T94" fmla="*/ 2595 w 4736"/>
              <a:gd name="T95" fmla="*/ 1425 h 1633"/>
              <a:gd name="T96" fmla="*/ 2648 w 4736"/>
              <a:gd name="T97" fmla="*/ 1425 h 1633"/>
              <a:gd name="T98" fmla="*/ 2750 w 4736"/>
              <a:gd name="T99" fmla="*/ 1425 h 1633"/>
              <a:gd name="T100" fmla="*/ 2750 w 4736"/>
              <a:gd name="T101" fmla="*/ 1633 h 1633"/>
              <a:gd name="T102" fmla="*/ 2775 w 4736"/>
              <a:gd name="T103" fmla="*/ 1633 h 1633"/>
              <a:gd name="T104" fmla="*/ 2950 w 4736"/>
              <a:gd name="T105" fmla="*/ 1633 h 1633"/>
              <a:gd name="T106" fmla="*/ 3557 w 4736"/>
              <a:gd name="T107" fmla="*/ 1633 h 1633"/>
              <a:gd name="T108" fmla="*/ 3732 w 4736"/>
              <a:gd name="T109" fmla="*/ 1633 h 1633"/>
              <a:gd name="T110" fmla="*/ 3768 w 4736"/>
              <a:gd name="T111" fmla="*/ 1633 h 1633"/>
              <a:gd name="T112" fmla="*/ 3989 w 4736"/>
              <a:gd name="T113" fmla="*/ 1633 h 1633"/>
              <a:gd name="T114" fmla="*/ 4366 w 4736"/>
              <a:gd name="T115" fmla="*/ 1633 h 1633"/>
              <a:gd name="T116" fmla="*/ 4736 w 4736"/>
              <a:gd name="T117" fmla="*/ 1633 h 16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736" h="1633">
                <a:moveTo>
                  <a:pt x="0" y="0"/>
                </a:moveTo>
                <a:lnTo>
                  <a:pt x="140" y="0"/>
                </a:lnTo>
                <a:lnTo>
                  <a:pt x="140" y="77"/>
                </a:lnTo>
                <a:lnTo>
                  <a:pt x="165" y="77"/>
                </a:lnTo>
                <a:lnTo>
                  <a:pt x="165" y="154"/>
                </a:lnTo>
                <a:lnTo>
                  <a:pt x="272" y="154"/>
                </a:lnTo>
                <a:lnTo>
                  <a:pt x="272" y="231"/>
                </a:lnTo>
                <a:lnTo>
                  <a:pt x="305" y="231"/>
                </a:lnTo>
                <a:lnTo>
                  <a:pt x="305" y="308"/>
                </a:lnTo>
                <a:lnTo>
                  <a:pt x="334" y="308"/>
                </a:lnTo>
                <a:lnTo>
                  <a:pt x="334" y="384"/>
                </a:lnTo>
                <a:lnTo>
                  <a:pt x="359" y="384"/>
                </a:lnTo>
                <a:lnTo>
                  <a:pt x="359" y="461"/>
                </a:lnTo>
                <a:lnTo>
                  <a:pt x="399" y="461"/>
                </a:lnTo>
                <a:lnTo>
                  <a:pt x="399" y="538"/>
                </a:lnTo>
                <a:lnTo>
                  <a:pt x="416" y="615"/>
                </a:lnTo>
                <a:lnTo>
                  <a:pt x="436" y="615"/>
                </a:lnTo>
                <a:lnTo>
                  <a:pt x="436" y="692"/>
                </a:lnTo>
                <a:lnTo>
                  <a:pt x="487" y="692"/>
                </a:lnTo>
                <a:lnTo>
                  <a:pt x="487" y="768"/>
                </a:lnTo>
                <a:lnTo>
                  <a:pt x="491" y="768"/>
                </a:lnTo>
                <a:lnTo>
                  <a:pt x="491" y="845"/>
                </a:lnTo>
                <a:lnTo>
                  <a:pt x="495" y="922"/>
                </a:lnTo>
                <a:lnTo>
                  <a:pt x="530" y="922"/>
                </a:lnTo>
                <a:lnTo>
                  <a:pt x="616" y="922"/>
                </a:lnTo>
                <a:lnTo>
                  <a:pt x="616" y="1001"/>
                </a:lnTo>
                <a:lnTo>
                  <a:pt x="622" y="1001"/>
                </a:lnTo>
                <a:lnTo>
                  <a:pt x="622" y="1080"/>
                </a:lnTo>
                <a:lnTo>
                  <a:pt x="666" y="1080"/>
                </a:lnTo>
                <a:lnTo>
                  <a:pt x="676" y="1162"/>
                </a:lnTo>
                <a:lnTo>
                  <a:pt x="687" y="1162"/>
                </a:lnTo>
                <a:lnTo>
                  <a:pt x="687" y="1245"/>
                </a:lnTo>
                <a:lnTo>
                  <a:pt x="706" y="1245"/>
                </a:lnTo>
                <a:lnTo>
                  <a:pt x="706" y="1327"/>
                </a:lnTo>
                <a:lnTo>
                  <a:pt x="1515" y="1327"/>
                </a:lnTo>
                <a:lnTo>
                  <a:pt x="1538" y="1327"/>
                </a:lnTo>
                <a:lnTo>
                  <a:pt x="1617" y="1327"/>
                </a:lnTo>
                <a:lnTo>
                  <a:pt x="1703" y="1327"/>
                </a:lnTo>
                <a:lnTo>
                  <a:pt x="1753" y="1327"/>
                </a:lnTo>
                <a:lnTo>
                  <a:pt x="1753" y="1425"/>
                </a:lnTo>
                <a:lnTo>
                  <a:pt x="1838" y="1425"/>
                </a:lnTo>
                <a:lnTo>
                  <a:pt x="2038" y="1425"/>
                </a:lnTo>
                <a:lnTo>
                  <a:pt x="2063" y="1425"/>
                </a:lnTo>
                <a:lnTo>
                  <a:pt x="2082" y="1425"/>
                </a:lnTo>
                <a:lnTo>
                  <a:pt x="2243" y="1425"/>
                </a:lnTo>
                <a:lnTo>
                  <a:pt x="2441" y="1425"/>
                </a:lnTo>
                <a:lnTo>
                  <a:pt x="2458" y="1425"/>
                </a:lnTo>
                <a:lnTo>
                  <a:pt x="2595" y="1425"/>
                </a:lnTo>
                <a:lnTo>
                  <a:pt x="2648" y="1425"/>
                </a:lnTo>
                <a:lnTo>
                  <a:pt x="2750" y="1425"/>
                </a:lnTo>
                <a:lnTo>
                  <a:pt x="2750" y="1633"/>
                </a:lnTo>
                <a:lnTo>
                  <a:pt x="2775" y="1633"/>
                </a:lnTo>
                <a:lnTo>
                  <a:pt x="2950" y="1633"/>
                </a:lnTo>
                <a:lnTo>
                  <a:pt x="3557" y="1633"/>
                </a:lnTo>
                <a:lnTo>
                  <a:pt x="3732" y="1633"/>
                </a:lnTo>
                <a:lnTo>
                  <a:pt x="3768" y="1633"/>
                </a:lnTo>
                <a:lnTo>
                  <a:pt x="3989" y="1633"/>
                </a:lnTo>
                <a:lnTo>
                  <a:pt x="4366" y="1633"/>
                </a:lnTo>
                <a:lnTo>
                  <a:pt x="4736" y="1633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CBC392F7-4E62-4041-9251-C4C0D475DAAA}"/>
              </a:ext>
            </a:extLst>
          </p:cNvPr>
          <p:cNvSpPr txBox="1"/>
          <p:nvPr/>
        </p:nvSpPr>
        <p:spPr>
          <a:xfrm>
            <a:off x="10201985" y="2580387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umin high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50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0EF228FA-837E-4A54-A27A-1D8C5118C92B}"/>
              </a:ext>
            </a:extLst>
          </p:cNvPr>
          <p:cNvSpPr txBox="1"/>
          <p:nvPr/>
        </p:nvSpPr>
        <p:spPr>
          <a:xfrm>
            <a:off x="10201985" y="4084380"/>
            <a:ext cx="8611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umin low 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43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B6E55815-5776-46D9-9BFE-21984564E7C1}"/>
              </a:ext>
            </a:extLst>
          </p:cNvPr>
          <p:cNvSpPr txBox="1"/>
          <p:nvPr/>
        </p:nvSpPr>
        <p:spPr>
          <a:xfrm>
            <a:off x="0" y="36576"/>
            <a:ext cx="2258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. 3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33389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>
            <a:extLst>
              <a:ext uri="{FF2B5EF4-FFF2-40B4-BE49-F238E27FC236}">
                <a16:creationId xmlns:a16="http://schemas.microsoft.com/office/drawing/2014/main" id="{B1115143-9495-4C44-BF33-8C57E8067E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1706" y="1541728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5815F14-F85F-4A2E-ADE1-1433426C194B}"/>
              </a:ext>
            </a:extLst>
          </p:cNvPr>
          <p:cNvSpPr txBox="1"/>
          <p:nvPr/>
        </p:nvSpPr>
        <p:spPr>
          <a:xfrm rot="16200000">
            <a:off x="-576404" y="3453764"/>
            <a:ext cx="2039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ability of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534DE1-D287-457F-A0F6-B8E647CDAB2E}"/>
              </a:ext>
            </a:extLst>
          </p:cNvPr>
          <p:cNvSpPr txBox="1"/>
          <p:nvPr/>
        </p:nvSpPr>
        <p:spPr>
          <a:xfrm>
            <a:off x="304828" y="1252023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B987067-4DCC-4966-A6DE-692BDA6FF9FB}"/>
              </a:ext>
            </a:extLst>
          </p:cNvPr>
          <p:cNvCxnSpPr>
            <a:cxnSpLocks/>
          </p:cNvCxnSpPr>
          <p:nvPr/>
        </p:nvCxnSpPr>
        <p:spPr>
          <a:xfrm>
            <a:off x="112543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6C36961C-999B-4EDD-B3E6-CBDFA3D37C0D}"/>
              </a:ext>
            </a:extLst>
          </p:cNvPr>
          <p:cNvGrpSpPr/>
          <p:nvPr/>
        </p:nvGrpSpPr>
        <p:grpSpPr>
          <a:xfrm>
            <a:off x="750302" y="1714573"/>
            <a:ext cx="4590085" cy="4124950"/>
            <a:chOff x="684686" y="1423988"/>
            <a:chExt cx="3857353" cy="3030859"/>
          </a:xfrm>
        </p:grpSpPr>
        <p:sp>
          <p:nvSpPr>
            <p:cNvPr id="9" name="Rectangle 45">
              <a:extLst>
                <a:ext uri="{FF2B5EF4-FFF2-40B4-BE49-F238E27FC236}">
                  <a16:creationId xmlns:a16="http://schemas.microsoft.com/office/drawing/2014/main" id="{CBACB78C-1C25-4532-8D62-56928E2D17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266" y="4341776"/>
              <a:ext cx="643918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(months)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5">
              <a:extLst>
                <a:ext uri="{FF2B5EF4-FFF2-40B4-BE49-F238E27FC236}">
                  <a16:creationId xmlns:a16="http://schemas.microsoft.com/office/drawing/2014/main" id="{E1D02969-B6CC-4C26-BACC-ACD7D529C7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700" y="1423988"/>
              <a:ext cx="12700" cy="127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6">
              <a:extLst>
                <a:ext uri="{FF2B5EF4-FFF2-40B4-BE49-F238E27FC236}">
                  <a16:creationId xmlns:a16="http://schemas.microsoft.com/office/drawing/2014/main" id="{81198873-E377-4E1A-AD98-0AA51313DF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963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7">
              <a:extLst>
                <a:ext uri="{FF2B5EF4-FFF2-40B4-BE49-F238E27FC236}">
                  <a16:creationId xmlns:a16="http://schemas.microsoft.com/office/drawing/2014/main" id="{C8DE1B10-58B7-469D-B3D6-286698AD8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849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8">
              <a:extLst>
                <a:ext uri="{FF2B5EF4-FFF2-40B4-BE49-F238E27FC236}">
                  <a16:creationId xmlns:a16="http://schemas.microsoft.com/office/drawing/2014/main" id="{6ABC764C-8783-4816-BF06-691BD682B1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3760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9">
              <a:extLst>
                <a:ext uri="{FF2B5EF4-FFF2-40B4-BE49-F238E27FC236}">
                  <a16:creationId xmlns:a16="http://schemas.microsoft.com/office/drawing/2014/main" id="{EF772464-5674-4F36-B431-D5A1B3690B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544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0">
              <a:extLst>
                <a:ext uri="{FF2B5EF4-FFF2-40B4-BE49-F238E27FC236}">
                  <a16:creationId xmlns:a16="http://schemas.microsoft.com/office/drawing/2014/main" id="{3D00D977-80C6-4BFB-9FD9-13E872ACB2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430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ine 11">
              <a:extLst>
                <a:ext uri="{FF2B5EF4-FFF2-40B4-BE49-F238E27FC236}">
                  <a16:creationId xmlns:a16="http://schemas.microsoft.com/office/drawing/2014/main" id="{34B059CA-9E11-47D2-A338-91488A0E7F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3341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12">
              <a:extLst>
                <a:ext uri="{FF2B5EF4-FFF2-40B4-BE49-F238E27FC236}">
                  <a16:creationId xmlns:a16="http://schemas.microsoft.com/office/drawing/2014/main" id="{0647C739-6981-4623-9319-1C1A52B811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1382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3">
              <a:extLst>
                <a:ext uri="{FF2B5EF4-FFF2-40B4-BE49-F238E27FC236}">
                  <a16:creationId xmlns:a16="http://schemas.microsoft.com/office/drawing/2014/main" id="{D88ED72B-9DF1-40FF-B5A8-BE99FA2CD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0239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Line 14">
              <a:extLst>
                <a:ext uri="{FF2B5EF4-FFF2-40B4-BE49-F238E27FC236}">
                  <a16:creationId xmlns:a16="http://schemas.microsoft.com/office/drawing/2014/main" id="{A40DE045-4A97-4A67-8612-92D82860BC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15">
              <a:extLst>
                <a:ext uri="{FF2B5EF4-FFF2-40B4-BE49-F238E27FC236}">
                  <a16:creationId xmlns:a16="http://schemas.microsoft.com/office/drawing/2014/main" id="{4DD4D25D-6E7E-4DA2-92EC-50A3CFEED0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27191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6">
              <a:extLst>
                <a:ext uri="{FF2B5EF4-FFF2-40B4-BE49-F238E27FC236}">
                  <a16:creationId xmlns:a16="http://schemas.microsoft.com/office/drawing/2014/main" id="{8B496F13-A082-4208-A7F9-85C06D29EB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26048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17">
              <a:extLst>
                <a:ext uri="{FF2B5EF4-FFF2-40B4-BE49-F238E27FC236}">
                  <a16:creationId xmlns:a16="http://schemas.microsoft.com/office/drawing/2014/main" id="{FBA2C5CA-79AD-4E57-94D1-56826141CF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18">
              <a:extLst>
                <a:ext uri="{FF2B5EF4-FFF2-40B4-BE49-F238E27FC236}">
                  <a16:creationId xmlns:a16="http://schemas.microsoft.com/office/drawing/2014/main" id="{C3BF85FB-BE6B-45B8-88A8-6ECD0878AE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19">
              <a:extLst>
                <a:ext uri="{FF2B5EF4-FFF2-40B4-BE49-F238E27FC236}">
                  <a16:creationId xmlns:a16="http://schemas.microsoft.com/office/drawing/2014/main" id="{2033FD13-F0F6-41DD-AA16-01D3CBFF4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0">
              <a:extLst>
                <a:ext uri="{FF2B5EF4-FFF2-40B4-BE49-F238E27FC236}">
                  <a16:creationId xmlns:a16="http://schemas.microsoft.com/office/drawing/2014/main" id="{92AA39B5-171D-43AA-85E0-1315472BEA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0968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1">
              <a:extLst>
                <a:ext uri="{FF2B5EF4-FFF2-40B4-BE49-F238E27FC236}">
                  <a16:creationId xmlns:a16="http://schemas.microsoft.com/office/drawing/2014/main" id="{289DCD35-9630-4A3D-96FD-0CE04DC5A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2">
              <a:extLst>
                <a:ext uri="{FF2B5EF4-FFF2-40B4-BE49-F238E27FC236}">
                  <a16:creationId xmlns:a16="http://schemas.microsoft.com/office/drawing/2014/main" id="{E337351A-31BE-4185-9886-4F53FC8BA6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3">
              <a:extLst>
                <a:ext uri="{FF2B5EF4-FFF2-40B4-BE49-F238E27FC236}">
                  <a16:creationId xmlns:a16="http://schemas.microsoft.com/office/drawing/2014/main" id="{900857D4-1914-4ADE-80E0-152D62FB4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Line 31">
              <a:extLst>
                <a:ext uri="{FF2B5EF4-FFF2-40B4-BE49-F238E27FC236}">
                  <a16:creationId xmlns:a16="http://schemas.microsoft.com/office/drawing/2014/main" id="{7FA77F55-D109-4E98-A053-D29199A982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48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1189238-2730-48F0-8D9D-22D4FB82B6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4086" y="40526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33">
              <a:extLst>
                <a:ext uri="{FF2B5EF4-FFF2-40B4-BE49-F238E27FC236}">
                  <a16:creationId xmlns:a16="http://schemas.microsoft.com/office/drawing/2014/main" id="{D413805E-51A9-41FC-9061-CF1657675E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085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B213B726-493F-4FB9-B05B-AE9EE342F6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96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Line 35">
              <a:extLst>
                <a:ext uri="{FF2B5EF4-FFF2-40B4-BE49-F238E27FC236}">
                  <a16:creationId xmlns:a16="http://schemas.microsoft.com/office/drawing/2014/main" id="{DDD502A4-DE86-4DC3-B29C-EFC83393AB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95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F111C11A-E5C4-4B2D-AC98-A68D3221B9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6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Line 37">
              <a:extLst>
                <a:ext uri="{FF2B5EF4-FFF2-40B4-BE49-F238E27FC236}">
                  <a16:creationId xmlns:a16="http://schemas.microsoft.com/office/drawing/2014/main" id="{775D1D83-9FE9-40CB-AFB9-A5A9287C65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32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F67B30F3-0B25-43D7-837B-1873B8EB9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43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Line 39">
              <a:extLst>
                <a:ext uri="{FF2B5EF4-FFF2-40B4-BE49-F238E27FC236}">
                  <a16:creationId xmlns:a16="http://schemas.microsoft.com/office/drawing/2014/main" id="{6F6C327E-9727-4064-BB56-C59ED00820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69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CCF4FC84-D300-443D-AAE9-98C7D890F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80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Line 41">
              <a:extLst>
                <a:ext uri="{FF2B5EF4-FFF2-40B4-BE49-F238E27FC236}">
                  <a16:creationId xmlns:a16="http://schemas.microsoft.com/office/drawing/2014/main" id="{DAE8F3C8-CACA-4F94-ADF9-F79B096BEE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79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AD6FC54-12FE-487C-83EB-D21AC3AB8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82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Line 43">
              <a:extLst>
                <a:ext uri="{FF2B5EF4-FFF2-40B4-BE49-F238E27FC236}">
                  <a16:creationId xmlns:a16="http://schemas.microsoft.com/office/drawing/2014/main" id="{8323EBA0-2C57-4E3F-BAE9-0A976938BE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516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3D90D5B-416D-43DD-AC87-E8FCD50957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9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Line 45">
              <a:extLst>
                <a:ext uri="{FF2B5EF4-FFF2-40B4-BE49-F238E27FC236}">
                  <a16:creationId xmlns:a16="http://schemas.microsoft.com/office/drawing/2014/main" id="{A8463F09-8C7B-41CF-9BA4-E746D01D14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53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6EE9B1D-AE33-4CD4-B551-F70364EB4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56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Line 47">
              <a:extLst>
                <a:ext uri="{FF2B5EF4-FFF2-40B4-BE49-F238E27FC236}">
                  <a16:creationId xmlns:a16="http://schemas.microsoft.com/office/drawing/2014/main" id="{3AA36CA2-BA8C-4C02-862C-8F182C9449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263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178291A9-1C61-480A-B80B-4EA006A90E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66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Line 49">
              <a:extLst>
                <a:ext uri="{FF2B5EF4-FFF2-40B4-BE49-F238E27FC236}">
                  <a16:creationId xmlns:a16="http://schemas.microsoft.com/office/drawing/2014/main" id="{52DE115A-8147-46DC-86A6-26EA20DC91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00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C65AA564-D89D-42AB-997D-CBB8EE30DC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03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16F26561-AF15-4FF8-B62D-C83F9A1FF6BD}"/>
                </a:ext>
              </a:extLst>
            </p:cNvPr>
            <p:cNvCxnSpPr/>
            <p:nvPr/>
          </p:nvCxnSpPr>
          <p:spPr>
            <a:xfrm flipV="1">
              <a:off x="1012367" y="1665919"/>
              <a:ext cx="0" cy="228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7838F753-8D26-4966-AD60-9ACAD8665A22}"/>
                </a:ext>
              </a:extLst>
            </p:cNvPr>
            <p:cNvCxnSpPr/>
            <p:nvPr/>
          </p:nvCxnSpPr>
          <p:spPr>
            <a:xfrm>
              <a:off x="995836" y="3963780"/>
              <a:ext cx="3505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A19CE15-0DA7-46A2-96AF-DE2CBA7EDC0C}"/>
              </a:ext>
            </a:extLst>
          </p:cNvPr>
          <p:cNvSpPr txBox="1"/>
          <p:nvPr/>
        </p:nvSpPr>
        <p:spPr>
          <a:xfrm rot="16200000">
            <a:off x="5323044" y="3286833"/>
            <a:ext cx="2373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disease-free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4">
            <a:extLst>
              <a:ext uri="{FF2B5EF4-FFF2-40B4-BE49-F238E27FC236}">
                <a16:creationId xmlns:a16="http://schemas.microsoft.com/office/drawing/2014/main" id="{5ADE0D89-CBF1-46CF-8F20-E2E07437B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2855" y="185285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62">
            <a:extLst>
              <a:ext uri="{FF2B5EF4-FFF2-40B4-BE49-F238E27FC236}">
                <a16:creationId xmlns:a16="http://schemas.microsoft.com/office/drawing/2014/main" id="{86AEE0FB-2B10-449F-9149-89178B9D17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001" y="158494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39EA555-CA1D-494C-8D48-CC121B1D8A6C}"/>
              </a:ext>
            </a:extLst>
          </p:cNvPr>
          <p:cNvSpPr txBox="1"/>
          <p:nvPr/>
        </p:nvSpPr>
        <p:spPr>
          <a:xfrm>
            <a:off x="6344898" y="12520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36218B09-70A0-492C-8B3F-BD3D19723A59}"/>
              </a:ext>
            </a:extLst>
          </p:cNvPr>
          <p:cNvGrpSpPr/>
          <p:nvPr/>
        </p:nvGrpSpPr>
        <p:grpSpPr>
          <a:xfrm>
            <a:off x="6886634" y="2077271"/>
            <a:ext cx="4590085" cy="3762263"/>
            <a:chOff x="7459931" y="1690480"/>
            <a:chExt cx="3857353" cy="2764367"/>
          </a:xfrm>
        </p:grpSpPr>
        <p:sp>
          <p:nvSpPr>
            <p:cNvPr id="62" name="Line 63">
              <a:extLst>
                <a:ext uri="{FF2B5EF4-FFF2-40B4-BE49-F238E27FC236}">
                  <a16:creationId xmlns:a16="http://schemas.microsoft.com/office/drawing/2014/main" id="{41F20D0C-E0AF-42F7-B58B-6C605EF4AF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9764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4">
              <a:extLst>
                <a:ext uri="{FF2B5EF4-FFF2-40B4-BE49-F238E27FC236}">
                  <a16:creationId xmlns:a16="http://schemas.microsoft.com/office/drawing/2014/main" id="{83553F3B-8E08-4AB6-A0F8-9B9A44F3F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8621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Line 65">
              <a:extLst>
                <a:ext uri="{FF2B5EF4-FFF2-40B4-BE49-F238E27FC236}">
                  <a16:creationId xmlns:a16="http://schemas.microsoft.com/office/drawing/2014/main" id="{4C7A6457-115C-48F4-88FB-17F890035C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7732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66">
              <a:extLst>
                <a:ext uri="{FF2B5EF4-FFF2-40B4-BE49-F238E27FC236}">
                  <a16:creationId xmlns:a16="http://schemas.microsoft.com/office/drawing/2014/main" id="{3305D2F6-BF2B-46EE-9670-112914A723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5573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7">
              <a:extLst>
                <a:ext uri="{FF2B5EF4-FFF2-40B4-BE49-F238E27FC236}">
                  <a16:creationId xmlns:a16="http://schemas.microsoft.com/office/drawing/2014/main" id="{DFD05DB3-5F97-4F0D-A0FA-EF45BB9435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4430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68">
              <a:extLst>
                <a:ext uri="{FF2B5EF4-FFF2-40B4-BE49-F238E27FC236}">
                  <a16:creationId xmlns:a16="http://schemas.microsoft.com/office/drawing/2014/main" id="{F04FC540-040E-48DD-9641-D4FE9BACC6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3541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69">
              <a:extLst>
                <a:ext uri="{FF2B5EF4-FFF2-40B4-BE49-F238E27FC236}">
                  <a16:creationId xmlns:a16="http://schemas.microsoft.com/office/drawing/2014/main" id="{B1E8748E-4C60-4417-8A52-2F0BA25A44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1509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70">
              <a:extLst>
                <a:ext uri="{FF2B5EF4-FFF2-40B4-BE49-F238E27FC236}">
                  <a16:creationId xmlns:a16="http://schemas.microsoft.com/office/drawing/2014/main" id="{E6DA65AB-DAB6-4C44-8C0E-56B5F98C7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0366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71">
              <a:extLst>
                <a:ext uri="{FF2B5EF4-FFF2-40B4-BE49-F238E27FC236}">
                  <a16:creationId xmlns:a16="http://schemas.microsoft.com/office/drawing/2014/main" id="{E0B76009-2AE0-4B69-ABEA-447C4F4FC7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72">
              <a:extLst>
                <a:ext uri="{FF2B5EF4-FFF2-40B4-BE49-F238E27FC236}">
                  <a16:creationId xmlns:a16="http://schemas.microsoft.com/office/drawing/2014/main" id="{93F0280B-851B-49B1-9957-8AA88487A7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7318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3">
              <a:extLst>
                <a:ext uri="{FF2B5EF4-FFF2-40B4-BE49-F238E27FC236}">
                  <a16:creationId xmlns:a16="http://schemas.microsoft.com/office/drawing/2014/main" id="{1307051F-6A0E-4F4D-B7FA-7BDD4E63C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6175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74">
              <a:extLst>
                <a:ext uri="{FF2B5EF4-FFF2-40B4-BE49-F238E27FC236}">
                  <a16:creationId xmlns:a16="http://schemas.microsoft.com/office/drawing/2014/main" id="{282329DE-F3D9-4A5E-83CE-3337E18411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75">
              <a:extLst>
                <a:ext uri="{FF2B5EF4-FFF2-40B4-BE49-F238E27FC236}">
                  <a16:creationId xmlns:a16="http://schemas.microsoft.com/office/drawing/2014/main" id="{A60AD0E9-8E61-4AC3-ADDD-4F7AC3567F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6">
              <a:extLst>
                <a:ext uri="{FF2B5EF4-FFF2-40B4-BE49-F238E27FC236}">
                  <a16:creationId xmlns:a16="http://schemas.microsoft.com/office/drawing/2014/main" id="{879224D7-A042-4A35-8D58-C7D3C5C07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7">
              <a:extLst>
                <a:ext uri="{FF2B5EF4-FFF2-40B4-BE49-F238E27FC236}">
                  <a16:creationId xmlns:a16="http://schemas.microsoft.com/office/drawing/2014/main" id="{08824B05-68E4-4F80-9155-B84D351080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109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78">
              <a:extLst>
                <a:ext uri="{FF2B5EF4-FFF2-40B4-BE49-F238E27FC236}">
                  <a16:creationId xmlns:a16="http://schemas.microsoft.com/office/drawing/2014/main" id="{61BDC263-2846-407F-BBF1-F5CD38FE77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9">
              <a:extLst>
                <a:ext uri="{FF2B5EF4-FFF2-40B4-BE49-F238E27FC236}">
                  <a16:creationId xmlns:a16="http://schemas.microsoft.com/office/drawing/2014/main" id="{38540C36-D3E0-4EC7-BBBF-90FE8F9A61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80">
              <a:extLst>
                <a:ext uri="{FF2B5EF4-FFF2-40B4-BE49-F238E27FC236}">
                  <a16:creationId xmlns:a16="http://schemas.microsoft.com/office/drawing/2014/main" id="{E3213FA5-EE36-4249-ABE8-B62B7BAB1F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88">
              <a:extLst>
                <a:ext uri="{FF2B5EF4-FFF2-40B4-BE49-F238E27FC236}">
                  <a16:creationId xmlns:a16="http://schemas.microsoft.com/office/drawing/2014/main" id="{FBC427DB-5467-4F7D-9CC8-D3A80CFD34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01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9">
              <a:extLst>
                <a:ext uri="{FF2B5EF4-FFF2-40B4-BE49-F238E27FC236}">
                  <a16:creationId xmlns:a16="http://schemas.microsoft.com/office/drawing/2014/main" id="{27F7BF80-1498-4857-9419-C89A9A3007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9331" y="40653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Line 90">
              <a:extLst>
                <a:ext uri="{FF2B5EF4-FFF2-40B4-BE49-F238E27FC236}">
                  <a16:creationId xmlns:a16="http://schemas.microsoft.com/office/drawing/2014/main" id="{25E60813-C7B0-4EEE-AFDF-31A3EF2679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3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91">
              <a:extLst>
                <a:ext uri="{FF2B5EF4-FFF2-40B4-BE49-F238E27FC236}">
                  <a16:creationId xmlns:a16="http://schemas.microsoft.com/office/drawing/2014/main" id="{30557258-2C77-421B-8051-C146DC7BE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4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Line 92">
              <a:extLst>
                <a:ext uri="{FF2B5EF4-FFF2-40B4-BE49-F238E27FC236}">
                  <a16:creationId xmlns:a16="http://schemas.microsoft.com/office/drawing/2014/main" id="{47B82442-125E-4C02-9613-56B5A88FCE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4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93">
              <a:extLst>
                <a:ext uri="{FF2B5EF4-FFF2-40B4-BE49-F238E27FC236}">
                  <a16:creationId xmlns:a16="http://schemas.microsoft.com/office/drawing/2014/main" id="{67DA3106-B6CE-4AF9-8129-9C14D84B2B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75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Line 94">
              <a:extLst>
                <a:ext uri="{FF2B5EF4-FFF2-40B4-BE49-F238E27FC236}">
                  <a16:creationId xmlns:a16="http://schemas.microsoft.com/office/drawing/2014/main" id="{EA2DA26D-0B9D-42AD-A6D3-8633AB6FD6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585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95">
              <a:extLst>
                <a:ext uri="{FF2B5EF4-FFF2-40B4-BE49-F238E27FC236}">
                  <a16:creationId xmlns:a16="http://schemas.microsoft.com/office/drawing/2014/main" id="{07BDF8C0-AD27-4329-9C53-8012ABD7D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96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96">
              <a:extLst>
                <a:ext uri="{FF2B5EF4-FFF2-40B4-BE49-F238E27FC236}">
                  <a16:creationId xmlns:a16="http://schemas.microsoft.com/office/drawing/2014/main" id="{706C4FB7-1F4B-4E59-A919-663C3D0EC7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52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97">
              <a:extLst>
                <a:ext uri="{FF2B5EF4-FFF2-40B4-BE49-F238E27FC236}">
                  <a16:creationId xmlns:a16="http://schemas.microsoft.com/office/drawing/2014/main" id="{3BFDB2BF-179C-4E31-AB61-684AD23FD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33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98">
              <a:extLst>
                <a:ext uri="{FF2B5EF4-FFF2-40B4-BE49-F238E27FC236}">
                  <a16:creationId xmlns:a16="http://schemas.microsoft.com/office/drawing/2014/main" id="{21AC52E1-371D-427F-BE5D-6A90BAF3EF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33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9">
              <a:extLst>
                <a:ext uri="{FF2B5EF4-FFF2-40B4-BE49-F238E27FC236}">
                  <a16:creationId xmlns:a16="http://schemas.microsoft.com/office/drawing/2014/main" id="{03D4FA76-5ACA-458B-A5D9-CE7E50488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935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100">
              <a:extLst>
                <a:ext uri="{FF2B5EF4-FFF2-40B4-BE49-F238E27FC236}">
                  <a16:creationId xmlns:a16="http://schemas.microsoft.com/office/drawing/2014/main" id="{5C2A47F8-A813-47B1-9253-05D0DB7651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69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01">
              <a:extLst>
                <a:ext uri="{FF2B5EF4-FFF2-40B4-BE49-F238E27FC236}">
                  <a16:creationId xmlns:a16="http://schemas.microsoft.com/office/drawing/2014/main" id="{5485F41C-78F6-49C2-8154-A0F1C2F2E8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72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Line 102">
              <a:extLst>
                <a:ext uri="{FF2B5EF4-FFF2-40B4-BE49-F238E27FC236}">
                  <a16:creationId xmlns:a16="http://schemas.microsoft.com/office/drawing/2014/main" id="{421C9D4D-AD36-4AFB-884C-190B38C9E8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0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103">
              <a:extLst>
                <a:ext uri="{FF2B5EF4-FFF2-40B4-BE49-F238E27FC236}">
                  <a16:creationId xmlns:a16="http://schemas.microsoft.com/office/drawing/2014/main" id="{ED7AF7CF-DBD1-40B3-81CA-5A2D8DE7E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Line 104">
              <a:extLst>
                <a:ext uri="{FF2B5EF4-FFF2-40B4-BE49-F238E27FC236}">
                  <a16:creationId xmlns:a16="http://schemas.microsoft.com/office/drawing/2014/main" id="{A4D98045-6380-4369-9C98-80EF061F76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01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105">
              <a:extLst>
                <a:ext uri="{FF2B5EF4-FFF2-40B4-BE49-F238E27FC236}">
                  <a16:creationId xmlns:a16="http://schemas.microsoft.com/office/drawing/2014/main" id="{64D288A7-D11F-453A-B3A3-758634E72C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1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Line 106">
              <a:extLst>
                <a:ext uri="{FF2B5EF4-FFF2-40B4-BE49-F238E27FC236}">
                  <a16:creationId xmlns:a16="http://schemas.microsoft.com/office/drawing/2014/main" id="{7A47BB4C-8D3C-41AB-A54D-B7D380450F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953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07">
              <a:extLst>
                <a:ext uri="{FF2B5EF4-FFF2-40B4-BE49-F238E27FC236}">
                  <a16:creationId xmlns:a16="http://schemas.microsoft.com/office/drawing/2014/main" id="{8A60A163-C5E9-4A76-BFEC-AF0AA369E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556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2" name="グループ化 101">
              <a:extLst>
                <a:ext uri="{FF2B5EF4-FFF2-40B4-BE49-F238E27FC236}">
                  <a16:creationId xmlns:a16="http://schemas.microsoft.com/office/drawing/2014/main" id="{DF8F8734-00E3-4B05-B0AF-441F97D44B2E}"/>
                </a:ext>
              </a:extLst>
            </p:cNvPr>
            <p:cNvGrpSpPr/>
            <p:nvPr/>
          </p:nvGrpSpPr>
          <p:grpSpPr>
            <a:xfrm>
              <a:off x="7790131" y="1690480"/>
              <a:ext cx="3505200" cy="2764367"/>
              <a:chOff x="7009954" y="1690480"/>
              <a:chExt cx="3505200" cy="2764367"/>
            </a:xfrm>
          </p:grpSpPr>
          <p:sp>
            <p:nvSpPr>
              <p:cNvPr id="104" name="Rectangle 45">
                <a:extLst>
                  <a:ext uri="{FF2B5EF4-FFF2-40B4-BE49-F238E27FC236}">
                    <a16:creationId xmlns:a16="http://schemas.microsoft.com/office/drawing/2014/main" id="{21DAD6E6-888F-4B4A-9BAF-5CC391EEC7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04384" y="4341776"/>
                <a:ext cx="643918" cy="113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Time (months)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374252DF-92F4-4689-B375-08CDA6EA4601}"/>
                  </a:ext>
                </a:extLst>
              </p:cNvPr>
              <p:cNvGrpSpPr/>
              <p:nvPr/>
            </p:nvGrpSpPr>
            <p:grpSpPr>
              <a:xfrm>
                <a:off x="7009954" y="1690480"/>
                <a:ext cx="3505200" cy="2286000"/>
                <a:chOff x="7009954" y="1690480"/>
                <a:chExt cx="3505200" cy="2286000"/>
              </a:xfrm>
            </p:grpSpPr>
            <p:cxnSp>
              <p:nvCxnSpPr>
                <p:cNvPr id="109" name="直線コネクタ 108">
                  <a:extLst>
                    <a:ext uri="{FF2B5EF4-FFF2-40B4-BE49-F238E27FC236}">
                      <a16:creationId xmlns:a16="http://schemas.microsoft.com/office/drawing/2014/main" id="{3002C42D-FC6D-4379-86CD-1E7574303729}"/>
                    </a:ext>
                  </a:extLst>
                </p:cNvPr>
                <p:cNvCxnSpPr/>
                <p:nvPr/>
              </p:nvCxnSpPr>
              <p:spPr>
                <a:xfrm flipV="1">
                  <a:off x="7009954" y="1690480"/>
                  <a:ext cx="0" cy="228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4C9FD613-8D49-4AE1-B91A-6F36E727A319}"/>
                    </a:ext>
                  </a:extLst>
                </p:cNvPr>
                <p:cNvCxnSpPr/>
                <p:nvPr/>
              </p:nvCxnSpPr>
              <p:spPr>
                <a:xfrm>
                  <a:off x="7009954" y="3972169"/>
                  <a:ext cx="3505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F04BF26B-DF10-4A98-9F57-2BA9449440F9}"/>
              </a:ext>
            </a:extLst>
          </p:cNvPr>
          <p:cNvCxnSpPr>
            <a:cxnSpLocks/>
          </p:cNvCxnSpPr>
          <p:nvPr/>
        </p:nvCxnSpPr>
        <p:spPr>
          <a:xfrm>
            <a:off x="746419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B15B3EB1-AC86-4E9A-9858-708DB9127620}"/>
              </a:ext>
            </a:extLst>
          </p:cNvPr>
          <p:cNvSpPr txBox="1"/>
          <p:nvPr/>
        </p:nvSpPr>
        <p:spPr>
          <a:xfrm>
            <a:off x="3841688" y="2233782"/>
            <a:ext cx="6864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MI high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1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D639AFD9-025D-4454-A021-2C90463C0EF8}"/>
              </a:ext>
            </a:extLst>
          </p:cNvPr>
          <p:cNvSpPr txBox="1"/>
          <p:nvPr/>
        </p:nvSpPr>
        <p:spPr>
          <a:xfrm>
            <a:off x="3939706" y="3390491"/>
            <a:ext cx="6511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MI low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2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0595C1BE-F240-4791-BD92-06310170C689}"/>
              </a:ext>
            </a:extLst>
          </p:cNvPr>
          <p:cNvSpPr txBox="1"/>
          <p:nvPr/>
        </p:nvSpPr>
        <p:spPr>
          <a:xfrm>
            <a:off x="1251945" y="4792787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=</a:t>
            </a:r>
            <a:r>
              <a:rPr kumimoji="1" lang="en-US" altLang="ja-JP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021</a:t>
            </a:r>
            <a:endParaRPr kumimoji="1" lang="ja-JP" altLang="en-US" sz="1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7AAFB70D-85D0-4456-BA9F-0048EE36819E}"/>
              </a:ext>
            </a:extLst>
          </p:cNvPr>
          <p:cNvSpPr txBox="1"/>
          <p:nvPr/>
        </p:nvSpPr>
        <p:spPr>
          <a:xfrm>
            <a:off x="7372153" y="4792787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</a:t>
            </a:r>
            <a:r>
              <a:rPr kumimoji="1" lang="en-US" altLang="ja-JP" sz="1000" b="0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=</a:t>
            </a:r>
            <a:r>
              <a:rPr kumimoji="1" lang="en-US" altLang="ja-JP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10</a:t>
            </a:r>
            <a:endParaRPr kumimoji="1" lang="ja-JP" altLang="en-US" sz="1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8" name="Freeform 28">
            <a:extLst>
              <a:ext uri="{FF2B5EF4-FFF2-40B4-BE49-F238E27FC236}">
                <a16:creationId xmlns:a16="http://schemas.microsoft.com/office/drawing/2014/main" id="{CF3C8244-710B-45CB-B216-077261BF7AE8}"/>
              </a:ext>
            </a:extLst>
          </p:cNvPr>
          <p:cNvSpPr>
            <a:spLocks/>
          </p:cNvSpPr>
          <p:nvPr/>
        </p:nvSpPr>
        <p:spPr bwMode="auto">
          <a:xfrm>
            <a:off x="1162241" y="2330181"/>
            <a:ext cx="3733800" cy="585788"/>
          </a:xfrm>
          <a:custGeom>
            <a:avLst/>
            <a:gdLst>
              <a:gd name="T0" fmla="*/ 0 w 2352"/>
              <a:gd name="T1" fmla="*/ 0 h 369"/>
              <a:gd name="T2" fmla="*/ 172 w 2352"/>
              <a:gd name="T3" fmla="*/ 0 h 369"/>
              <a:gd name="T4" fmla="*/ 172 w 2352"/>
              <a:gd name="T5" fmla="*/ 40 h 369"/>
              <a:gd name="T6" fmla="*/ 196 w 2352"/>
              <a:gd name="T7" fmla="*/ 40 h 369"/>
              <a:gd name="T8" fmla="*/ 217 w 2352"/>
              <a:gd name="T9" fmla="*/ 40 h 369"/>
              <a:gd name="T10" fmla="*/ 217 w 2352"/>
              <a:gd name="T11" fmla="*/ 83 h 369"/>
              <a:gd name="T12" fmla="*/ 264 w 2352"/>
              <a:gd name="T13" fmla="*/ 83 h 369"/>
              <a:gd name="T14" fmla="*/ 329 w 2352"/>
              <a:gd name="T15" fmla="*/ 83 h 369"/>
              <a:gd name="T16" fmla="*/ 365 w 2352"/>
              <a:gd name="T17" fmla="*/ 83 h 369"/>
              <a:gd name="T18" fmla="*/ 398 w 2352"/>
              <a:gd name="T19" fmla="*/ 83 h 369"/>
              <a:gd name="T20" fmla="*/ 404 w 2352"/>
              <a:gd name="T21" fmla="*/ 83 h 369"/>
              <a:gd name="T22" fmla="*/ 490 w 2352"/>
              <a:gd name="T23" fmla="*/ 83 h 369"/>
              <a:gd name="T24" fmla="*/ 490 w 2352"/>
              <a:gd name="T25" fmla="*/ 131 h 369"/>
              <a:gd name="T26" fmla="*/ 526 w 2352"/>
              <a:gd name="T27" fmla="*/ 131 h 369"/>
              <a:gd name="T28" fmla="*/ 538 w 2352"/>
              <a:gd name="T29" fmla="*/ 131 h 369"/>
              <a:gd name="T30" fmla="*/ 616 w 2352"/>
              <a:gd name="T31" fmla="*/ 131 h 369"/>
              <a:gd name="T32" fmla="*/ 616 w 2352"/>
              <a:gd name="T33" fmla="*/ 183 h 369"/>
              <a:gd name="T34" fmla="*/ 636 w 2352"/>
              <a:gd name="T35" fmla="*/ 183 h 369"/>
              <a:gd name="T36" fmla="*/ 753 w 2352"/>
              <a:gd name="T37" fmla="*/ 183 h 369"/>
              <a:gd name="T38" fmla="*/ 777 w 2352"/>
              <a:gd name="T39" fmla="*/ 183 h 369"/>
              <a:gd name="T40" fmla="*/ 777 w 2352"/>
              <a:gd name="T41" fmla="*/ 239 h 369"/>
              <a:gd name="T42" fmla="*/ 803 w 2352"/>
              <a:gd name="T43" fmla="*/ 239 h 369"/>
              <a:gd name="T44" fmla="*/ 813 w 2352"/>
              <a:gd name="T45" fmla="*/ 239 h 369"/>
              <a:gd name="T46" fmla="*/ 813 w 2352"/>
              <a:gd name="T47" fmla="*/ 296 h 369"/>
              <a:gd name="T48" fmla="*/ 816 w 2352"/>
              <a:gd name="T49" fmla="*/ 296 h 369"/>
              <a:gd name="T50" fmla="*/ 826 w 2352"/>
              <a:gd name="T51" fmla="*/ 296 h 369"/>
              <a:gd name="T52" fmla="*/ 972 w 2352"/>
              <a:gd name="T53" fmla="*/ 296 h 369"/>
              <a:gd name="T54" fmla="*/ 991 w 2352"/>
              <a:gd name="T55" fmla="*/ 296 h 369"/>
              <a:gd name="T56" fmla="*/ 1035 w 2352"/>
              <a:gd name="T57" fmla="*/ 296 h 369"/>
              <a:gd name="T58" fmla="*/ 1149 w 2352"/>
              <a:gd name="T59" fmla="*/ 296 h 369"/>
              <a:gd name="T60" fmla="*/ 1149 w 2352"/>
              <a:gd name="T61" fmla="*/ 369 h 369"/>
              <a:gd name="T62" fmla="*/ 1223 w 2352"/>
              <a:gd name="T63" fmla="*/ 369 h 369"/>
              <a:gd name="T64" fmla="*/ 1289 w 2352"/>
              <a:gd name="T65" fmla="*/ 369 h 369"/>
              <a:gd name="T66" fmla="*/ 1379 w 2352"/>
              <a:gd name="T67" fmla="*/ 369 h 369"/>
              <a:gd name="T68" fmla="*/ 1461 w 2352"/>
              <a:gd name="T69" fmla="*/ 369 h 369"/>
              <a:gd name="T70" fmla="*/ 1518 w 2352"/>
              <a:gd name="T71" fmla="*/ 369 h 369"/>
              <a:gd name="T72" fmla="*/ 1576 w 2352"/>
              <a:gd name="T73" fmla="*/ 369 h 369"/>
              <a:gd name="T74" fmla="*/ 1734 w 2352"/>
              <a:gd name="T75" fmla="*/ 369 h 369"/>
              <a:gd name="T76" fmla="*/ 1767 w 2352"/>
              <a:gd name="T77" fmla="*/ 369 h 369"/>
              <a:gd name="T78" fmla="*/ 1772 w 2352"/>
              <a:gd name="T79" fmla="*/ 369 h 369"/>
              <a:gd name="T80" fmla="*/ 1810 w 2352"/>
              <a:gd name="T81" fmla="*/ 369 h 369"/>
              <a:gd name="T82" fmla="*/ 1857 w 2352"/>
              <a:gd name="T83" fmla="*/ 369 h 369"/>
              <a:gd name="T84" fmla="*/ 1872 w 2352"/>
              <a:gd name="T85" fmla="*/ 369 h 369"/>
              <a:gd name="T86" fmla="*/ 1878 w 2352"/>
              <a:gd name="T87" fmla="*/ 369 h 369"/>
              <a:gd name="T88" fmla="*/ 1944 w 2352"/>
              <a:gd name="T89" fmla="*/ 369 h 369"/>
              <a:gd name="T90" fmla="*/ 1981 w 2352"/>
              <a:gd name="T91" fmla="*/ 369 h 369"/>
              <a:gd name="T92" fmla="*/ 2057 w 2352"/>
              <a:gd name="T93" fmla="*/ 369 h 369"/>
              <a:gd name="T94" fmla="*/ 2065 w 2352"/>
              <a:gd name="T95" fmla="*/ 369 h 369"/>
              <a:gd name="T96" fmla="*/ 2352 w 2352"/>
              <a:gd name="T97" fmla="*/ 369 h 3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</a:cxnLst>
            <a:rect l="0" t="0" r="r" b="b"/>
            <a:pathLst>
              <a:path w="2352" h="369">
                <a:moveTo>
                  <a:pt x="0" y="0"/>
                </a:moveTo>
                <a:lnTo>
                  <a:pt x="172" y="0"/>
                </a:lnTo>
                <a:lnTo>
                  <a:pt x="172" y="40"/>
                </a:lnTo>
                <a:lnTo>
                  <a:pt x="196" y="40"/>
                </a:lnTo>
                <a:lnTo>
                  <a:pt x="217" y="40"/>
                </a:lnTo>
                <a:lnTo>
                  <a:pt x="217" y="83"/>
                </a:lnTo>
                <a:lnTo>
                  <a:pt x="264" y="83"/>
                </a:lnTo>
                <a:lnTo>
                  <a:pt x="329" y="83"/>
                </a:lnTo>
                <a:lnTo>
                  <a:pt x="365" y="83"/>
                </a:lnTo>
                <a:lnTo>
                  <a:pt x="398" y="83"/>
                </a:lnTo>
                <a:lnTo>
                  <a:pt x="404" y="83"/>
                </a:lnTo>
                <a:lnTo>
                  <a:pt x="490" y="83"/>
                </a:lnTo>
                <a:lnTo>
                  <a:pt x="490" y="131"/>
                </a:lnTo>
                <a:lnTo>
                  <a:pt x="526" y="131"/>
                </a:lnTo>
                <a:lnTo>
                  <a:pt x="538" y="131"/>
                </a:lnTo>
                <a:lnTo>
                  <a:pt x="616" y="131"/>
                </a:lnTo>
                <a:lnTo>
                  <a:pt x="616" y="183"/>
                </a:lnTo>
                <a:lnTo>
                  <a:pt x="636" y="183"/>
                </a:lnTo>
                <a:lnTo>
                  <a:pt x="753" y="183"/>
                </a:lnTo>
                <a:lnTo>
                  <a:pt x="777" y="183"/>
                </a:lnTo>
                <a:lnTo>
                  <a:pt x="777" y="239"/>
                </a:lnTo>
                <a:lnTo>
                  <a:pt x="803" y="239"/>
                </a:lnTo>
                <a:lnTo>
                  <a:pt x="813" y="239"/>
                </a:lnTo>
                <a:lnTo>
                  <a:pt x="813" y="296"/>
                </a:lnTo>
                <a:lnTo>
                  <a:pt x="816" y="296"/>
                </a:lnTo>
                <a:lnTo>
                  <a:pt x="826" y="296"/>
                </a:lnTo>
                <a:lnTo>
                  <a:pt x="972" y="296"/>
                </a:lnTo>
                <a:lnTo>
                  <a:pt x="991" y="296"/>
                </a:lnTo>
                <a:lnTo>
                  <a:pt x="1035" y="296"/>
                </a:lnTo>
                <a:lnTo>
                  <a:pt x="1149" y="296"/>
                </a:lnTo>
                <a:lnTo>
                  <a:pt x="1149" y="369"/>
                </a:lnTo>
                <a:lnTo>
                  <a:pt x="1223" y="369"/>
                </a:lnTo>
                <a:lnTo>
                  <a:pt x="1289" y="369"/>
                </a:lnTo>
                <a:lnTo>
                  <a:pt x="1379" y="369"/>
                </a:lnTo>
                <a:lnTo>
                  <a:pt x="1461" y="369"/>
                </a:lnTo>
                <a:lnTo>
                  <a:pt x="1518" y="369"/>
                </a:lnTo>
                <a:lnTo>
                  <a:pt x="1576" y="369"/>
                </a:lnTo>
                <a:lnTo>
                  <a:pt x="1734" y="369"/>
                </a:lnTo>
                <a:lnTo>
                  <a:pt x="1767" y="369"/>
                </a:lnTo>
                <a:lnTo>
                  <a:pt x="1772" y="369"/>
                </a:lnTo>
                <a:lnTo>
                  <a:pt x="1810" y="369"/>
                </a:lnTo>
                <a:lnTo>
                  <a:pt x="1857" y="369"/>
                </a:lnTo>
                <a:lnTo>
                  <a:pt x="1872" y="369"/>
                </a:lnTo>
                <a:lnTo>
                  <a:pt x="1878" y="369"/>
                </a:lnTo>
                <a:lnTo>
                  <a:pt x="1944" y="369"/>
                </a:lnTo>
                <a:lnTo>
                  <a:pt x="1981" y="369"/>
                </a:lnTo>
                <a:lnTo>
                  <a:pt x="2057" y="369"/>
                </a:lnTo>
                <a:lnTo>
                  <a:pt x="2065" y="369"/>
                </a:lnTo>
                <a:lnTo>
                  <a:pt x="2352" y="369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" name="Freeform 29">
            <a:extLst>
              <a:ext uri="{FF2B5EF4-FFF2-40B4-BE49-F238E27FC236}">
                <a16:creationId xmlns:a16="http://schemas.microsoft.com/office/drawing/2014/main" id="{75A1515D-60A7-4F83-8723-3D9BED0BCE1E}"/>
              </a:ext>
            </a:extLst>
          </p:cNvPr>
          <p:cNvSpPr>
            <a:spLocks/>
          </p:cNvSpPr>
          <p:nvPr/>
        </p:nvSpPr>
        <p:spPr bwMode="auto">
          <a:xfrm>
            <a:off x="1162241" y="2330181"/>
            <a:ext cx="3865562" cy="1784350"/>
          </a:xfrm>
          <a:custGeom>
            <a:avLst/>
            <a:gdLst>
              <a:gd name="T0" fmla="*/ 230 w 2435"/>
              <a:gd name="T1" fmla="*/ 0 h 1124"/>
              <a:gd name="T2" fmla="*/ 332 w 2435"/>
              <a:gd name="T3" fmla="*/ 33 h 1124"/>
              <a:gd name="T4" fmla="*/ 340 w 2435"/>
              <a:gd name="T5" fmla="*/ 65 h 1124"/>
              <a:gd name="T6" fmla="*/ 370 w 2435"/>
              <a:gd name="T7" fmla="*/ 99 h 1124"/>
              <a:gd name="T8" fmla="*/ 388 w 2435"/>
              <a:gd name="T9" fmla="*/ 132 h 1124"/>
              <a:gd name="T10" fmla="*/ 414 w 2435"/>
              <a:gd name="T11" fmla="*/ 132 h 1124"/>
              <a:gd name="T12" fmla="*/ 427 w 2435"/>
              <a:gd name="T13" fmla="*/ 168 h 1124"/>
              <a:gd name="T14" fmla="*/ 448 w 2435"/>
              <a:gd name="T15" fmla="*/ 204 h 1124"/>
              <a:gd name="T16" fmla="*/ 485 w 2435"/>
              <a:gd name="T17" fmla="*/ 240 h 1124"/>
              <a:gd name="T18" fmla="*/ 488 w 2435"/>
              <a:gd name="T19" fmla="*/ 312 h 1124"/>
              <a:gd name="T20" fmla="*/ 506 w 2435"/>
              <a:gd name="T21" fmla="*/ 350 h 1124"/>
              <a:gd name="T22" fmla="*/ 513 w 2435"/>
              <a:gd name="T23" fmla="*/ 387 h 1124"/>
              <a:gd name="T24" fmla="*/ 617 w 2435"/>
              <a:gd name="T25" fmla="*/ 387 h 1124"/>
              <a:gd name="T26" fmla="*/ 635 w 2435"/>
              <a:gd name="T27" fmla="*/ 426 h 1124"/>
              <a:gd name="T28" fmla="*/ 681 w 2435"/>
              <a:gd name="T29" fmla="*/ 426 h 1124"/>
              <a:gd name="T30" fmla="*/ 746 w 2435"/>
              <a:gd name="T31" fmla="*/ 426 h 1124"/>
              <a:gd name="T32" fmla="*/ 786 w 2435"/>
              <a:gd name="T33" fmla="*/ 426 h 1124"/>
              <a:gd name="T34" fmla="*/ 820 w 2435"/>
              <a:gd name="T35" fmla="*/ 472 h 1124"/>
              <a:gd name="T36" fmla="*/ 909 w 2435"/>
              <a:gd name="T37" fmla="*/ 472 h 1124"/>
              <a:gd name="T38" fmla="*/ 988 w 2435"/>
              <a:gd name="T39" fmla="*/ 527 h 1124"/>
              <a:gd name="T40" fmla="*/ 1024 w 2435"/>
              <a:gd name="T41" fmla="*/ 527 h 1124"/>
              <a:gd name="T42" fmla="*/ 1037 w 2435"/>
              <a:gd name="T43" fmla="*/ 527 h 1124"/>
              <a:gd name="T44" fmla="*/ 1049 w 2435"/>
              <a:gd name="T45" fmla="*/ 600 h 1124"/>
              <a:gd name="T46" fmla="*/ 1125 w 2435"/>
              <a:gd name="T47" fmla="*/ 600 h 1124"/>
              <a:gd name="T48" fmla="*/ 1169 w 2435"/>
              <a:gd name="T49" fmla="*/ 677 h 1124"/>
              <a:gd name="T50" fmla="*/ 1222 w 2435"/>
              <a:gd name="T51" fmla="*/ 677 h 1124"/>
              <a:gd name="T52" fmla="*/ 1316 w 2435"/>
              <a:gd name="T53" fmla="*/ 677 h 1124"/>
              <a:gd name="T54" fmla="*/ 1358 w 2435"/>
              <a:gd name="T55" fmla="*/ 789 h 1124"/>
              <a:gd name="T56" fmla="*/ 1549 w 2435"/>
              <a:gd name="T57" fmla="*/ 789 h 1124"/>
              <a:gd name="T58" fmla="*/ 1591 w 2435"/>
              <a:gd name="T59" fmla="*/ 938 h 1124"/>
              <a:gd name="T60" fmla="*/ 1854 w 2435"/>
              <a:gd name="T61" fmla="*/ 1124 h 1124"/>
              <a:gd name="T62" fmla="*/ 2169 w 2435"/>
              <a:gd name="T63" fmla="*/ 1124 h 1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2435" h="1124">
                <a:moveTo>
                  <a:pt x="0" y="0"/>
                </a:moveTo>
                <a:lnTo>
                  <a:pt x="230" y="0"/>
                </a:lnTo>
                <a:lnTo>
                  <a:pt x="230" y="33"/>
                </a:lnTo>
                <a:lnTo>
                  <a:pt x="332" y="33"/>
                </a:lnTo>
                <a:lnTo>
                  <a:pt x="333" y="65"/>
                </a:lnTo>
                <a:lnTo>
                  <a:pt x="340" y="65"/>
                </a:lnTo>
                <a:lnTo>
                  <a:pt x="340" y="99"/>
                </a:lnTo>
                <a:lnTo>
                  <a:pt x="370" y="99"/>
                </a:lnTo>
                <a:lnTo>
                  <a:pt x="388" y="99"/>
                </a:lnTo>
                <a:lnTo>
                  <a:pt x="388" y="132"/>
                </a:lnTo>
                <a:lnTo>
                  <a:pt x="402" y="132"/>
                </a:lnTo>
                <a:lnTo>
                  <a:pt x="414" y="132"/>
                </a:lnTo>
                <a:lnTo>
                  <a:pt x="414" y="168"/>
                </a:lnTo>
                <a:lnTo>
                  <a:pt x="427" y="168"/>
                </a:lnTo>
                <a:lnTo>
                  <a:pt x="427" y="204"/>
                </a:lnTo>
                <a:lnTo>
                  <a:pt x="448" y="204"/>
                </a:lnTo>
                <a:lnTo>
                  <a:pt x="448" y="240"/>
                </a:lnTo>
                <a:lnTo>
                  <a:pt x="485" y="240"/>
                </a:lnTo>
                <a:lnTo>
                  <a:pt x="485" y="276"/>
                </a:lnTo>
                <a:lnTo>
                  <a:pt x="488" y="312"/>
                </a:lnTo>
                <a:lnTo>
                  <a:pt x="506" y="312"/>
                </a:lnTo>
                <a:lnTo>
                  <a:pt x="506" y="350"/>
                </a:lnTo>
                <a:lnTo>
                  <a:pt x="513" y="350"/>
                </a:lnTo>
                <a:lnTo>
                  <a:pt x="513" y="387"/>
                </a:lnTo>
                <a:lnTo>
                  <a:pt x="591" y="387"/>
                </a:lnTo>
                <a:lnTo>
                  <a:pt x="617" y="387"/>
                </a:lnTo>
                <a:lnTo>
                  <a:pt x="635" y="387"/>
                </a:lnTo>
                <a:lnTo>
                  <a:pt x="635" y="426"/>
                </a:lnTo>
                <a:lnTo>
                  <a:pt x="650" y="426"/>
                </a:lnTo>
                <a:lnTo>
                  <a:pt x="681" y="426"/>
                </a:lnTo>
                <a:lnTo>
                  <a:pt x="722" y="426"/>
                </a:lnTo>
                <a:lnTo>
                  <a:pt x="746" y="426"/>
                </a:lnTo>
                <a:lnTo>
                  <a:pt x="765" y="426"/>
                </a:lnTo>
                <a:lnTo>
                  <a:pt x="786" y="426"/>
                </a:lnTo>
                <a:lnTo>
                  <a:pt x="786" y="472"/>
                </a:lnTo>
                <a:lnTo>
                  <a:pt x="820" y="472"/>
                </a:lnTo>
                <a:lnTo>
                  <a:pt x="846" y="472"/>
                </a:lnTo>
                <a:lnTo>
                  <a:pt x="909" y="472"/>
                </a:lnTo>
                <a:lnTo>
                  <a:pt x="988" y="472"/>
                </a:lnTo>
                <a:lnTo>
                  <a:pt x="988" y="527"/>
                </a:lnTo>
                <a:lnTo>
                  <a:pt x="1012" y="527"/>
                </a:lnTo>
                <a:lnTo>
                  <a:pt x="1024" y="527"/>
                </a:lnTo>
                <a:lnTo>
                  <a:pt x="1035" y="527"/>
                </a:lnTo>
                <a:lnTo>
                  <a:pt x="1037" y="527"/>
                </a:lnTo>
                <a:lnTo>
                  <a:pt x="1047" y="527"/>
                </a:lnTo>
                <a:lnTo>
                  <a:pt x="1049" y="600"/>
                </a:lnTo>
                <a:lnTo>
                  <a:pt x="1115" y="600"/>
                </a:lnTo>
                <a:lnTo>
                  <a:pt x="1125" y="600"/>
                </a:lnTo>
                <a:lnTo>
                  <a:pt x="1125" y="677"/>
                </a:lnTo>
                <a:lnTo>
                  <a:pt x="1169" y="677"/>
                </a:lnTo>
                <a:lnTo>
                  <a:pt x="1192" y="677"/>
                </a:lnTo>
                <a:lnTo>
                  <a:pt x="1222" y="677"/>
                </a:lnTo>
                <a:lnTo>
                  <a:pt x="1264" y="677"/>
                </a:lnTo>
                <a:lnTo>
                  <a:pt x="1316" y="677"/>
                </a:lnTo>
                <a:lnTo>
                  <a:pt x="1316" y="789"/>
                </a:lnTo>
                <a:lnTo>
                  <a:pt x="1358" y="789"/>
                </a:lnTo>
                <a:lnTo>
                  <a:pt x="1466" y="789"/>
                </a:lnTo>
                <a:lnTo>
                  <a:pt x="1549" y="789"/>
                </a:lnTo>
                <a:lnTo>
                  <a:pt x="1549" y="938"/>
                </a:lnTo>
                <a:lnTo>
                  <a:pt x="1591" y="938"/>
                </a:lnTo>
                <a:lnTo>
                  <a:pt x="1854" y="938"/>
                </a:lnTo>
                <a:lnTo>
                  <a:pt x="1854" y="1124"/>
                </a:lnTo>
                <a:lnTo>
                  <a:pt x="2061" y="1124"/>
                </a:lnTo>
                <a:lnTo>
                  <a:pt x="2169" y="1124"/>
                </a:lnTo>
                <a:lnTo>
                  <a:pt x="2435" y="1124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" name="Freeform 85">
            <a:extLst>
              <a:ext uri="{FF2B5EF4-FFF2-40B4-BE49-F238E27FC236}">
                <a16:creationId xmlns:a16="http://schemas.microsoft.com/office/drawing/2014/main" id="{DD061529-7F0C-4F84-B07E-5FE3EE99F13D}"/>
              </a:ext>
            </a:extLst>
          </p:cNvPr>
          <p:cNvSpPr>
            <a:spLocks/>
          </p:cNvSpPr>
          <p:nvPr/>
        </p:nvSpPr>
        <p:spPr bwMode="auto">
          <a:xfrm>
            <a:off x="7285791" y="2346661"/>
            <a:ext cx="3619500" cy="908050"/>
          </a:xfrm>
          <a:custGeom>
            <a:avLst/>
            <a:gdLst>
              <a:gd name="T0" fmla="*/ 0 w 2280"/>
              <a:gd name="T1" fmla="*/ 0 h 572"/>
              <a:gd name="T2" fmla="*/ 98 w 2280"/>
              <a:gd name="T3" fmla="*/ 0 h 572"/>
              <a:gd name="T4" fmla="*/ 98 w 2280"/>
              <a:gd name="T5" fmla="*/ 40 h 572"/>
              <a:gd name="T6" fmla="*/ 143 w 2280"/>
              <a:gd name="T7" fmla="*/ 40 h 572"/>
              <a:gd name="T8" fmla="*/ 143 w 2280"/>
              <a:gd name="T9" fmla="*/ 80 h 572"/>
              <a:gd name="T10" fmla="*/ 152 w 2280"/>
              <a:gd name="T11" fmla="*/ 80 h 572"/>
              <a:gd name="T12" fmla="*/ 152 w 2280"/>
              <a:gd name="T13" fmla="*/ 120 h 572"/>
              <a:gd name="T14" fmla="*/ 160 w 2280"/>
              <a:gd name="T15" fmla="*/ 120 h 572"/>
              <a:gd name="T16" fmla="*/ 160 w 2280"/>
              <a:gd name="T17" fmla="*/ 161 h 572"/>
              <a:gd name="T18" fmla="*/ 187 w 2280"/>
              <a:gd name="T19" fmla="*/ 161 h 572"/>
              <a:gd name="T20" fmla="*/ 205 w 2280"/>
              <a:gd name="T21" fmla="*/ 161 h 572"/>
              <a:gd name="T22" fmla="*/ 205 w 2280"/>
              <a:gd name="T23" fmla="*/ 201 h 572"/>
              <a:gd name="T24" fmla="*/ 214 w 2280"/>
              <a:gd name="T25" fmla="*/ 201 h 572"/>
              <a:gd name="T26" fmla="*/ 214 w 2280"/>
              <a:gd name="T27" fmla="*/ 251 h 572"/>
              <a:gd name="T28" fmla="*/ 258 w 2280"/>
              <a:gd name="T29" fmla="*/ 251 h 572"/>
              <a:gd name="T30" fmla="*/ 294 w 2280"/>
              <a:gd name="T31" fmla="*/ 251 h 572"/>
              <a:gd name="T32" fmla="*/ 294 w 2280"/>
              <a:gd name="T33" fmla="*/ 291 h 572"/>
              <a:gd name="T34" fmla="*/ 321 w 2280"/>
              <a:gd name="T35" fmla="*/ 291 h 572"/>
              <a:gd name="T36" fmla="*/ 347 w 2280"/>
              <a:gd name="T37" fmla="*/ 291 h 572"/>
              <a:gd name="T38" fmla="*/ 347 w 2280"/>
              <a:gd name="T39" fmla="*/ 331 h 572"/>
              <a:gd name="T40" fmla="*/ 356 w 2280"/>
              <a:gd name="T41" fmla="*/ 331 h 572"/>
              <a:gd name="T42" fmla="*/ 374 w 2280"/>
              <a:gd name="T43" fmla="*/ 331 h 572"/>
              <a:gd name="T44" fmla="*/ 374 w 2280"/>
              <a:gd name="T45" fmla="*/ 382 h 572"/>
              <a:gd name="T46" fmla="*/ 383 w 2280"/>
              <a:gd name="T47" fmla="*/ 382 h 572"/>
              <a:gd name="T48" fmla="*/ 392 w 2280"/>
              <a:gd name="T49" fmla="*/ 382 h 572"/>
              <a:gd name="T50" fmla="*/ 525 w 2280"/>
              <a:gd name="T51" fmla="*/ 382 h 572"/>
              <a:gd name="T52" fmla="*/ 552 w 2280"/>
              <a:gd name="T53" fmla="*/ 382 h 572"/>
              <a:gd name="T54" fmla="*/ 552 w 2280"/>
              <a:gd name="T55" fmla="*/ 432 h 572"/>
              <a:gd name="T56" fmla="*/ 730 w 2280"/>
              <a:gd name="T57" fmla="*/ 432 h 572"/>
              <a:gd name="T58" fmla="*/ 775 w 2280"/>
              <a:gd name="T59" fmla="*/ 432 h 572"/>
              <a:gd name="T60" fmla="*/ 793 w 2280"/>
              <a:gd name="T61" fmla="*/ 432 h 572"/>
              <a:gd name="T62" fmla="*/ 793 w 2280"/>
              <a:gd name="T63" fmla="*/ 492 h 572"/>
              <a:gd name="T64" fmla="*/ 801 w 2280"/>
              <a:gd name="T65" fmla="*/ 492 h 572"/>
              <a:gd name="T66" fmla="*/ 944 w 2280"/>
              <a:gd name="T67" fmla="*/ 492 h 572"/>
              <a:gd name="T68" fmla="*/ 962 w 2280"/>
              <a:gd name="T69" fmla="*/ 492 h 572"/>
              <a:gd name="T70" fmla="*/ 1006 w 2280"/>
              <a:gd name="T71" fmla="*/ 492 h 572"/>
              <a:gd name="T72" fmla="*/ 1184 w 2280"/>
              <a:gd name="T73" fmla="*/ 492 h 572"/>
              <a:gd name="T74" fmla="*/ 1247 w 2280"/>
              <a:gd name="T75" fmla="*/ 492 h 572"/>
              <a:gd name="T76" fmla="*/ 1336 w 2280"/>
              <a:gd name="T77" fmla="*/ 492 h 572"/>
              <a:gd name="T78" fmla="*/ 1443 w 2280"/>
              <a:gd name="T79" fmla="*/ 492 h 572"/>
              <a:gd name="T80" fmla="*/ 1443 w 2280"/>
              <a:gd name="T81" fmla="*/ 572 h 572"/>
              <a:gd name="T82" fmla="*/ 1469 w 2280"/>
              <a:gd name="T83" fmla="*/ 572 h 572"/>
              <a:gd name="T84" fmla="*/ 1523 w 2280"/>
              <a:gd name="T85" fmla="*/ 572 h 572"/>
              <a:gd name="T86" fmla="*/ 1710 w 2280"/>
              <a:gd name="T87" fmla="*/ 572 h 572"/>
              <a:gd name="T88" fmla="*/ 1719 w 2280"/>
              <a:gd name="T89" fmla="*/ 572 h 572"/>
              <a:gd name="T90" fmla="*/ 1754 w 2280"/>
              <a:gd name="T91" fmla="*/ 572 h 572"/>
              <a:gd name="T92" fmla="*/ 1790 w 2280"/>
              <a:gd name="T93" fmla="*/ 572 h 572"/>
              <a:gd name="T94" fmla="*/ 1817 w 2280"/>
              <a:gd name="T95" fmla="*/ 572 h 572"/>
              <a:gd name="T96" fmla="*/ 1817 w 2280"/>
              <a:gd name="T97" fmla="*/ 572 h 572"/>
              <a:gd name="T98" fmla="*/ 1879 w 2280"/>
              <a:gd name="T99" fmla="*/ 572 h 572"/>
              <a:gd name="T100" fmla="*/ 1914 w 2280"/>
              <a:gd name="T101" fmla="*/ 572 h 572"/>
              <a:gd name="T102" fmla="*/ 2004 w 2280"/>
              <a:gd name="T103" fmla="*/ 572 h 572"/>
              <a:gd name="T104" fmla="*/ 2280 w 2280"/>
              <a:gd name="T105" fmla="*/ 572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2280" h="572">
                <a:moveTo>
                  <a:pt x="0" y="0"/>
                </a:moveTo>
                <a:lnTo>
                  <a:pt x="98" y="0"/>
                </a:lnTo>
                <a:lnTo>
                  <a:pt x="98" y="40"/>
                </a:lnTo>
                <a:lnTo>
                  <a:pt x="143" y="40"/>
                </a:lnTo>
                <a:lnTo>
                  <a:pt x="143" y="80"/>
                </a:lnTo>
                <a:lnTo>
                  <a:pt x="152" y="80"/>
                </a:lnTo>
                <a:lnTo>
                  <a:pt x="152" y="120"/>
                </a:lnTo>
                <a:lnTo>
                  <a:pt x="160" y="120"/>
                </a:lnTo>
                <a:lnTo>
                  <a:pt x="160" y="161"/>
                </a:lnTo>
                <a:lnTo>
                  <a:pt x="187" y="161"/>
                </a:lnTo>
                <a:lnTo>
                  <a:pt x="205" y="161"/>
                </a:lnTo>
                <a:lnTo>
                  <a:pt x="205" y="201"/>
                </a:lnTo>
                <a:lnTo>
                  <a:pt x="214" y="201"/>
                </a:lnTo>
                <a:lnTo>
                  <a:pt x="214" y="251"/>
                </a:lnTo>
                <a:lnTo>
                  <a:pt x="258" y="251"/>
                </a:lnTo>
                <a:lnTo>
                  <a:pt x="294" y="251"/>
                </a:lnTo>
                <a:lnTo>
                  <a:pt x="294" y="291"/>
                </a:lnTo>
                <a:lnTo>
                  <a:pt x="321" y="291"/>
                </a:lnTo>
                <a:lnTo>
                  <a:pt x="347" y="291"/>
                </a:lnTo>
                <a:lnTo>
                  <a:pt x="347" y="331"/>
                </a:lnTo>
                <a:lnTo>
                  <a:pt x="356" y="331"/>
                </a:lnTo>
                <a:lnTo>
                  <a:pt x="374" y="331"/>
                </a:lnTo>
                <a:lnTo>
                  <a:pt x="374" y="382"/>
                </a:lnTo>
                <a:lnTo>
                  <a:pt x="383" y="382"/>
                </a:lnTo>
                <a:lnTo>
                  <a:pt x="392" y="382"/>
                </a:lnTo>
                <a:lnTo>
                  <a:pt x="525" y="382"/>
                </a:lnTo>
                <a:lnTo>
                  <a:pt x="552" y="382"/>
                </a:lnTo>
                <a:lnTo>
                  <a:pt x="552" y="432"/>
                </a:lnTo>
                <a:lnTo>
                  <a:pt x="730" y="432"/>
                </a:lnTo>
                <a:lnTo>
                  <a:pt x="775" y="432"/>
                </a:lnTo>
                <a:lnTo>
                  <a:pt x="793" y="432"/>
                </a:lnTo>
                <a:lnTo>
                  <a:pt x="793" y="492"/>
                </a:lnTo>
                <a:lnTo>
                  <a:pt x="801" y="492"/>
                </a:lnTo>
                <a:lnTo>
                  <a:pt x="944" y="492"/>
                </a:lnTo>
                <a:lnTo>
                  <a:pt x="962" y="492"/>
                </a:lnTo>
                <a:lnTo>
                  <a:pt x="1006" y="492"/>
                </a:lnTo>
                <a:lnTo>
                  <a:pt x="1184" y="492"/>
                </a:lnTo>
                <a:lnTo>
                  <a:pt x="1247" y="492"/>
                </a:lnTo>
                <a:lnTo>
                  <a:pt x="1336" y="492"/>
                </a:lnTo>
                <a:lnTo>
                  <a:pt x="1443" y="492"/>
                </a:lnTo>
                <a:lnTo>
                  <a:pt x="1443" y="572"/>
                </a:lnTo>
                <a:lnTo>
                  <a:pt x="1469" y="572"/>
                </a:lnTo>
                <a:lnTo>
                  <a:pt x="1523" y="572"/>
                </a:lnTo>
                <a:lnTo>
                  <a:pt x="1710" y="572"/>
                </a:lnTo>
                <a:lnTo>
                  <a:pt x="1719" y="572"/>
                </a:lnTo>
                <a:lnTo>
                  <a:pt x="1754" y="572"/>
                </a:lnTo>
                <a:lnTo>
                  <a:pt x="1790" y="572"/>
                </a:lnTo>
                <a:lnTo>
                  <a:pt x="1817" y="572"/>
                </a:lnTo>
                <a:lnTo>
                  <a:pt x="1817" y="572"/>
                </a:lnTo>
                <a:lnTo>
                  <a:pt x="1879" y="572"/>
                </a:lnTo>
                <a:lnTo>
                  <a:pt x="1914" y="572"/>
                </a:lnTo>
                <a:lnTo>
                  <a:pt x="2004" y="572"/>
                </a:lnTo>
                <a:lnTo>
                  <a:pt x="2280" y="572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" name="Freeform 86">
            <a:extLst>
              <a:ext uri="{FF2B5EF4-FFF2-40B4-BE49-F238E27FC236}">
                <a16:creationId xmlns:a16="http://schemas.microsoft.com/office/drawing/2014/main" id="{31B134CF-08D6-488A-873C-D58FC681B0E4}"/>
              </a:ext>
            </a:extLst>
          </p:cNvPr>
          <p:cNvSpPr>
            <a:spLocks/>
          </p:cNvSpPr>
          <p:nvPr/>
        </p:nvSpPr>
        <p:spPr bwMode="auto">
          <a:xfrm>
            <a:off x="7285791" y="2346661"/>
            <a:ext cx="3335337" cy="1385888"/>
          </a:xfrm>
          <a:custGeom>
            <a:avLst/>
            <a:gdLst>
              <a:gd name="T0" fmla="*/ 71 w 2101"/>
              <a:gd name="T1" fmla="*/ 0 h 873"/>
              <a:gd name="T2" fmla="*/ 80 w 2101"/>
              <a:gd name="T3" fmla="*/ 40 h 873"/>
              <a:gd name="T4" fmla="*/ 116 w 2101"/>
              <a:gd name="T5" fmla="*/ 70 h 873"/>
              <a:gd name="T6" fmla="*/ 134 w 2101"/>
              <a:gd name="T7" fmla="*/ 100 h 873"/>
              <a:gd name="T8" fmla="*/ 134 w 2101"/>
              <a:gd name="T9" fmla="*/ 161 h 873"/>
              <a:gd name="T10" fmla="*/ 152 w 2101"/>
              <a:gd name="T11" fmla="*/ 191 h 873"/>
              <a:gd name="T12" fmla="*/ 160 w 2101"/>
              <a:gd name="T13" fmla="*/ 221 h 873"/>
              <a:gd name="T14" fmla="*/ 169 w 2101"/>
              <a:gd name="T15" fmla="*/ 261 h 873"/>
              <a:gd name="T16" fmla="*/ 196 w 2101"/>
              <a:gd name="T17" fmla="*/ 291 h 873"/>
              <a:gd name="T18" fmla="*/ 214 w 2101"/>
              <a:gd name="T19" fmla="*/ 321 h 873"/>
              <a:gd name="T20" fmla="*/ 223 w 2101"/>
              <a:gd name="T21" fmla="*/ 351 h 873"/>
              <a:gd name="T22" fmla="*/ 232 w 2101"/>
              <a:gd name="T23" fmla="*/ 412 h 873"/>
              <a:gd name="T24" fmla="*/ 232 w 2101"/>
              <a:gd name="T25" fmla="*/ 442 h 873"/>
              <a:gd name="T26" fmla="*/ 241 w 2101"/>
              <a:gd name="T27" fmla="*/ 482 h 873"/>
              <a:gd name="T28" fmla="*/ 303 w 2101"/>
              <a:gd name="T29" fmla="*/ 512 h 873"/>
              <a:gd name="T30" fmla="*/ 321 w 2101"/>
              <a:gd name="T31" fmla="*/ 542 h 873"/>
              <a:gd name="T32" fmla="*/ 330 w 2101"/>
              <a:gd name="T33" fmla="*/ 602 h 873"/>
              <a:gd name="T34" fmla="*/ 330 w 2101"/>
              <a:gd name="T35" fmla="*/ 643 h 873"/>
              <a:gd name="T36" fmla="*/ 338 w 2101"/>
              <a:gd name="T37" fmla="*/ 673 h 873"/>
              <a:gd name="T38" fmla="*/ 436 w 2101"/>
              <a:gd name="T39" fmla="*/ 673 h 873"/>
              <a:gd name="T40" fmla="*/ 570 w 2101"/>
              <a:gd name="T41" fmla="*/ 673 h 873"/>
              <a:gd name="T42" fmla="*/ 704 w 2101"/>
              <a:gd name="T43" fmla="*/ 673 h 873"/>
              <a:gd name="T44" fmla="*/ 819 w 2101"/>
              <a:gd name="T45" fmla="*/ 673 h 873"/>
              <a:gd name="T46" fmla="*/ 846 w 2101"/>
              <a:gd name="T47" fmla="*/ 713 h 873"/>
              <a:gd name="T48" fmla="*/ 980 w 2101"/>
              <a:gd name="T49" fmla="*/ 713 h 873"/>
              <a:gd name="T50" fmla="*/ 1006 w 2101"/>
              <a:gd name="T51" fmla="*/ 713 h 873"/>
              <a:gd name="T52" fmla="*/ 1015 w 2101"/>
              <a:gd name="T53" fmla="*/ 713 h 873"/>
              <a:gd name="T54" fmla="*/ 1131 w 2101"/>
              <a:gd name="T55" fmla="*/ 713 h 873"/>
              <a:gd name="T56" fmla="*/ 1175 w 2101"/>
              <a:gd name="T57" fmla="*/ 713 h 873"/>
              <a:gd name="T58" fmla="*/ 1220 w 2101"/>
              <a:gd name="T59" fmla="*/ 713 h 873"/>
              <a:gd name="T60" fmla="*/ 1318 w 2101"/>
              <a:gd name="T61" fmla="*/ 713 h 873"/>
              <a:gd name="T62" fmla="*/ 1416 w 2101"/>
              <a:gd name="T63" fmla="*/ 873 h 873"/>
              <a:gd name="T64" fmla="*/ 1799 w 2101"/>
              <a:gd name="T65" fmla="*/ 873 h 873"/>
              <a:gd name="T66" fmla="*/ 2101 w 2101"/>
              <a:gd name="T67" fmla="*/ 873 h 8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2101" h="873">
                <a:moveTo>
                  <a:pt x="0" y="0"/>
                </a:moveTo>
                <a:lnTo>
                  <a:pt x="71" y="0"/>
                </a:lnTo>
                <a:lnTo>
                  <a:pt x="71" y="40"/>
                </a:lnTo>
                <a:lnTo>
                  <a:pt x="80" y="40"/>
                </a:lnTo>
                <a:lnTo>
                  <a:pt x="80" y="70"/>
                </a:lnTo>
                <a:lnTo>
                  <a:pt x="116" y="70"/>
                </a:lnTo>
                <a:lnTo>
                  <a:pt x="116" y="100"/>
                </a:lnTo>
                <a:lnTo>
                  <a:pt x="134" y="100"/>
                </a:lnTo>
                <a:lnTo>
                  <a:pt x="134" y="130"/>
                </a:lnTo>
                <a:lnTo>
                  <a:pt x="134" y="161"/>
                </a:lnTo>
                <a:lnTo>
                  <a:pt x="152" y="161"/>
                </a:lnTo>
                <a:lnTo>
                  <a:pt x="152" y="191"/>
                </a:lnTo>
                <a:lnTo>
                  <a:pt x="160" y="191"/>
                </a:lnTo>
                <a:lnTo>
                  <a:pt x="160" y="221"/>
                </a:lnTo>
                <a:lnTo>
                  <a:pt x="169" y="221"/>
                </a:lnTo>
                <a:lnTo>
                  <a:pt x="169" y="261"/>
                </a:lnTo>
                <a:lnTo>
                  <a:pt x="196" y="261"/>
                </a:lnTo>
                <a:lnTo>
                  <a:pt x="196" y="291"/>
                </a:lnTo>
                <a:lnTo>
                  <a:pt x="214" y="291"/>
                </a:lnTo>
                <a:lnTo>
                  <a:pt x="214" y="321"/>
                </a:lnTo>
                <a:lnTo>
                  <a:pt x="214" y="351"/>
                </a:lnTo>
                <a:lnTo>
                  <a:pt x="223" y="351"/>
                </a:lnTo>
                <a:lnTo>
                  <a:pt x="223" y="382"/>
                </a:lnTo>
                <a:lnTo>
                  <a:pt x="232" y="412"/>
                </a:lnTo>
                <a:lnTo>
                  <a:pt x="232" y="412"/>
                </a:lnTo>
                <a:lnTo>
                  <a:pt x="232" y="442"/>
                </a:lnTo>
                <a:lnTo>
                  <a:pt x="241" y="442"/>
                </a:lnTo>
                <a:lnTo>
                  <a:pt x="241" y="482"/>
                </a:lnTo>
                <a:lnTo>
                  <a:pt x="241" y="512"/>
                </a:lnTo>
                <a:lnTo>
                  <a:pt x="303" y="512"/>
                </a:lnTo>
                <a:lnTo>
                  <a:pt x="303" y="542"/>
                </a:lnTo>
                <a:lnTo>
                  <a:pt x="321" y="542"/>
                </a:lnTo>
                <a:lnTo>
                  <a:pt x="321" y="572"/>
                </a:lnTo>
                <a:lnTo>
                  <a:pt x="330" y="602"/>
                </a:lnTo>
                <a:lnTo>
                  <a:pt x="330" y="602"/>
                </a:lnTo>
                <a:lnTo>
                  <a:pt x="330" y="643"/>
                </a:lnTo>
                <a:lnTo>
                  <a:pt x="338" y="643"/>
                </a:lnTo>
                <a:lnTo>
                  <a:pt x="338" y="673"/>
                </a:lnTo>
                <a:lnTo>
                  <a:pt x="392" y="673"/>
                </a:lnTo>
                <a:lnTo>
                  <a:pt x="436" y="673"/>
                </a:lnTo>
                <a:lnTo>
                  <a:pt x="490" y="673"/>
                </a:lnTo>
                <a:lnTo>
                  <a:pt x="570" y="673"/>
                </a:lnTo>
                <a:lnTo>
                  <a:pt x="659" y="673"/>
                </a:lnTo>
                <a:lnTo>
                  <a:pt x="704" y="673"/>
                </a:lnTo>
                <a:lnTo>
                  <a:pt x="739" y="673"/>
                </a:lnTo>
                <a:lnTo>
                  <a:pt x="819" y="673"/>
                </a:lnTo>
                <a:lnTo>
                  <a:pt x="846" y="673"/>
                </a:lnTo>
                <a:lnTo>
                  <a:pt x="846" y="713"/>
                </a:lnTo>
                <a:lnTo>
                  <a:pt x="882" y="713"/>
                </a:lnTo>
                <a:lnTo>
                  <a:pt x="980" y="713"/>
                </a:lnTo>
                <a:lnTo>
                  <a:pt x="988" y="713"/>
                </a:lnTo>
                <a:lnTo>
                  <a:pt x="1006" y="713"/>
                </a:lnTo>
                <a:lnTo>
                  <a:pt x="1006" y="713"/>
                </a:lnTo>
                <a:lnTo>
                  <a:pt x="1015" y="713"/>
                </a:lnTo>
                <a:lnTo>
                  <a:pt x="1078" y="713"/>
                </a:lnTo>
                <a:lnTo>
                  <a:pt x="1131" y="713"/>
                </a:lnTo>
                <a:lnTo>
                  <a:pt x="1158" y="713"/>
                </a:lnTo>
                <a:lnTo>
                  <a:pt x="1175" y="713"/>
                </a:lnTo>
                <a:lnTo>
                  <a:pt x="1184" y="713"/>
                </a:lnTo>
                <a:lnTo>
                  <a:pt x="1220" y="713"/>
                </a:lnTo>
                <a:lnTo>
                  <a:pt x="1273" y="713"/>
                </a:lnTo>
                <a:lnTo>
                  <a:pt x="1318" y="713"/>
                </a:lnTo>
                <a:lnTo>
                  <a:pt x="1327" y="873"/>
                </a:lnTo>
                <a:lnTo>
                  <a:pt x="1416" y="873"/>
                </a:lnTo>
                <a:lnTo>
                  <a:pt x="1541" y="873"/>
                </a:lnTo>
                <a:lnTo>
                  <a:pt x="1799" y="873"/>
                </a:lnTo>
                <a:lnTo>
                  <a:pt x="1995" y="873"/>
                </a:lnTo>
                <a:lnTo>
                  <a:pt x="2101" y="873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92B5BAB1-1348-4316-85AA-95F8DF11816F}"/>
              </a:ext>
            </a:extLst>
          </p:cNvPr>
          <p:cNvSpPr txBox="1"/>
          <p:nvPr/>
        </p:nvSpPr>
        <p:spPr>
          <a:xfrm>
            <a:off x="10113351" y="2768644"/>
            <a:ext cx="6864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MI high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1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1B27C0A1-A503-4ADA-B4AD-4077A630B15E}"/>
              </a:ext>
            </a:extLst>
          </p:cNvPr>
          <p:cNvSpPr txBox="1"/>
          <p:nvPr/>
        </p:nvSpPr>
        <p:spPr>
          <a:xfrm>
            <a:off x="10211369" y="3925353"/>
            <a:ext cx="6511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MI low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2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E18ADEEE-1AED-4BE6-AD38-559313E18BD9}"/>
              </a:ext>
            </a:extLst>
          </p:cNvPr>
          <p:cNvSpPr txBox="1"/>
          <p:nvPr/>
        </p:nvSpPr>
        <p:spPr>
          <a:xfrm>
            <a:off x="0" y="36576"/>
            <a:ext cx="2258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. 3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59619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4</TotalTime>
  <Words>178</Words>
  <Application>Microsoft Office PowerPoint</Application>
  <PresentationFormat>ワイド画面</PresentationFormat>
  <Paragraphs>9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>UNITCOM P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zo Ide</dc:creator>
  <cp:lastModifiedBy>正造 井出</cp:lastModifiedBy>
  <cp:revision>60</cp:revision>
  <dcterms:created xsi:type="dcterms:W3CDTF">2017-05-15T10:58:12Z</dcterms:created>
  <dcterms:modified xsi:type="dcterms:W3CDTF">2021-01-05T07:03:45Z</dcterms:modified>
</cp:coreProperties>
</file>